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741"/>
    <p:restoredTop sz="95775"/>
  </p:normalViewPr>
  <p:slideViewPr>
    <p:cSldViewPr snapToGrid="0">
      <p:cViewPr varScale="1">
        <p:scale>
          <a:sx n="108" d="100"/>
          <a:sy n="108" d="100"/>
        </p:scale>
        <p:origin x="224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7C01E1-0BB4-5011-31B6-6506586043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99A25A-6E6E-8D95-487B-72A1B4CF66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F38755-1F8C-3D0D-339E-E73FE42D0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E86AA-EBF5-A84F-A7E3-63FE6DB1B4F2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8B1695-154D-2985-C9C4-7EB249EA2F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C2C708-642B-7230-E478-E8D319C02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25041-D280-7045-AA29-001EF23A1E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7629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A5B5B8-5D0A-8B42-A4AE-99270B8126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ACF412-4A2A-4A27-78E0-584454DB83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FD60EB-BB7E-04BC-40A6-1D8F0BDF8F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E86AA-EBF5-A84F-A7E3-63FE6DB1B4F2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37E990-EE78-63F8-6BF9-711812F957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297AE1-3D14-ABE4-8B47-5C05A6848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25041-D280-7045-AA29-001EF23A1E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08806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D9D0DCC-3597-2DFD-6EBB-BD6E6B3C93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635545-EDEB-89AC-8922-3D36A705ED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55AF4C-C019-354B-68CB-798CB48639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E86AA-EBF5-A84F-A7E3-63FE6DB1B4F2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AA7B24-C18F-0521-55BF-C2B7A8993A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49BDBA-6768-7747-6340-B0AD75110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25041-D280-7045-AA29-001EF23A1E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6701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7BB01E-EADD-BBB4-5CC9-CFCA2378F3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2113FC-D057-CDD7-33BF-B4BD50746F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6FADEF-EA9A-0A5C-83EE-2AA0FBE213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E86AA-EBF5-A84F-A7E3-63FE6DB1B4F2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82086B-C3C2-2969-DF0E-3012732CFF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13C858-9B10-E98F-EC4E-91AD9159D5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25041-D280-7045-AA29-001EF23A1E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0293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469A9A-27C8-5D2F-607A-63F9186A20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B0D00F-8220-E3F0-01AC-57859A603A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78B433-A47F-BECF-5873-0F1EB70D3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E86AA-EBF5-A84F-A7E3-63FE6DB1B4F2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E520F4-190F-F96E-8DAB-FBE9449585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E60FA3-EF26-CC2E-590C-CE660D47E4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25041-D280-7045-AA29-001EF23A1E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5874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39514D-D7E7-193F-B4E7-691A791E98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E5A9D8-4098-8D0C-BF72-F694A849210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A2980E-BDFA-A708-826E-D899E142D2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96D0F2-EB8B-63E6-18CB-F670589BF1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E86AA-EBF5-A84F-A7E3-63FE6DB1B4F2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0CA3EA-D7EC-C4F7-125B-2FEE363018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B90845-C3FA-2934-353C-FC5BC076E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25041-D280-7045-AA29-001EF23A1E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46163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21B51C-B87D-6983-AD43-BDDCC92AD9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6E770F-55BC-D6D7-9E66-B029264573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0201FC-B6F7-BA1E-B4E7-EEA7B78BCC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8F4128C-E982-F4FD-04CD-07D5FA5B89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F074811-D8BC-F941-F031-35DA1ACAB4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0706659-D6D7-6A37-EC74-8BEAF520E9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E86AA-EBF5-A84F-A7E3-63FE6DB1B4F2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5C8A624-8CEF-1FA7-B3C7-A96283E1D5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97FDAC6-57F7-7A3E-BBD3-D1841480E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25041-D280-7045-AA29-001EF23A1E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2197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BB54C6-9C67-9C2F-40F2-F6B50DE15B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BC9D978-6CD4-A750-0CAC-57305CEACE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E86AA-EBF5-A84F-A7E3-63FE6DB1B4F2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7DEFE84-9B30-B6D7-A7F8-B571347F19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BBD2B8A-2325-AB0E-5546-4A116D2B9E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25041-D280-7045-AA29-001EF23A1E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5317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289D5DC-6114-CEC1-93C7-88978BBD89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E86AA-EBF5-A84F-A7E3-63FE6DB1B4F2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B7660B1-63BA-ED47-72AD-0CBA61C0B2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8381C06-1C0F-A94B-D12A-8676232E7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25041-D280-7045-AA29-001EF23A1E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8078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4E7331-22AF-4081-8717-87468BDB65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31CB8F-C914-488B-F3C4-1D0D9315B9A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41410F-7553-4DDC-1C8F-5BB7163A27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7FDB8A-8F5F-69DA-CA5A-37FC970A2E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E86AA-EBF5-A84F-A7E3-63FE6DB1B4F2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25D86B-AC4B-0887-5774-809D84EABE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CB3C9B-9B32-537D-FD24-9DFA834DBD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25041-D280-7045-AA29-001EF23A1E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0371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04A2DC-5C18-FFFA-66D7-1C22C27E3E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1677B26-18F1-5DD7-EB12-D2A95BE76A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BC88AF-5EA9-218D-AB25-D937178A82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BA3E0F-381B-73BB-AF3E-6883EA1565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E86AA-EBF5-A84F-A7E3-63FE6DB1B4F2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A77373-E106-1256-5388-909C3971D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D4927C-DC5A-B558-EF24-C570D602E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825041-D280-7045-AA29-001EF23A1E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9763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3E7425A-C9B9-FF5B-4688-D8975AC1BE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9E9339-24B8-C78B-1943-D7F5FB8326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F023CE-D9D0-4D26-3C76-CF1BEF3D07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3E86AA-EBF5-A84F-A7E3-63FE6DB1B4F2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477282-76FE-079F-F0FD-27932E4DD2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7D9EB2-A831-AC68-387E-FDEB68DB82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825041-D280-7045-AA29-001EF23A1E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7402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CB9277E0-9EBA-5BB8-AD94-EA9C1CBC1064}"/>
              </a:ext>
            </a:extLst>
          </p:cNvPr>
          <p:cNvGrpSpPr/>
          <p:nvPr/>
        </p:nvGrpSpPr>
        <p:grpSpPr>
          <a:xfrm>
            <a:off x="2218501" y="2439610"/>
            <a:ext cx="1281511" cy="564043"/>
            <a:chOff x="1334139" y="3031667"/>
            <a:chExt cx="1281511" cy="564043"/>
          </a:xfrm>
        </p:grpSpPr>
        <p:pic>
          <p:nvPicPr>
            <p:cNvPr id="5" name="Picture 4" descr="Cell clipart cell culture, Picture #165188 cell clipart cell culture">
              <a:extLst>
                <a:ext uri="{FF2B5EF4-FFF2-40B4-BE49-F238E27FC236}">
                  <a16:creationId xmlns:a16="http://schemas.microsoft.com/office/drawing/2014/main" id="{4C9A9745-027A-8160-060B-0A1615EF77F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34139" y="3031667"/>
              <a:ext cx="1281511" cy="56404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A50B6175-DBBB-0188-EA73-B4900011094E}"/>
                </a:ext>
              </a:extLst>
            </p:cNvPr>
            <p:cNvGrpSpPr/>
            <p:nvPr/>
          </p:nvGrpSpPr>
          <p:grpSpPr>
            <a:xfrm>
              <a:off x="1386453" y="3343819"/>
              <a:ext cx="470314" cy="197102"/>
              <a:chOff x="3445660" y="3729082"/>
              <a:chExt cx="620066" cy="259861"/>
            </a:xfrm>
          </p:grpSpPr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F025BF3D-47F6-E434-08DF-A875C217DA55}"/>
                  </a:ext>
                </a:extLst>
              </p:cNvPr>
              <p:cNvGrpSpPr/>
              <p:nvPr/>
            </p:nvGrpSpPr>
            <p:grpSpPr>
              <a:xfrm>
                <a:off x="3445660" y="3768831"/>
                <a:ext cx="306461" cy="123091"/>
                <a:chOff x="3429000" y="3700462"/>
                <a:chExt cx="448256" cy="180043"/>
              </a:xfrm>
            </p:grpSpPr>
            <p:sp>
              <p:nvSpPr>
                <p:cNvPr id="34" name="Freeform 33">
                  <a:extLst>
                    <a:ext uri="{FF2B5EF4-FFF2-40B4-BE49-F238E27FC236}">
                      <a16:creationId xmlns:a16="http://schemas.microsoft.com/office/drawing/2014/main" id="{9857EE6F-8FCF-71CA-BF31-4D6AF3AE947C}"/>
                    </a:ext>
                  </a:extLst>
                </p:cNvPr>
                <p:cNvSpPr/>
                <p:nvPr/>
              </p:nvSpPr>
              <p:spPr>
                <a:xfrm>
                  <a:off x="3429000" y="3700462"/>
                  <a:ext cx="448256" cy="180043"/>
                </a:xfrm>
                <a:custGeom>
                  <a:avLst/>
                  <a:gdLst>
                    <a:gd name="connsiteX0" fmla="*/ 107156 w 500062"/>
                    <a:gd name="connsiteY0" fmla="*/ 64294 h 285750"/>
                    <a:gd name="connsiteX1" fmla="*/ 107156 w 500062"/>
                    <a:gd name="connsiteY1" fmla="*/ 64294 h 285750"/>
                    <a:gd name="connsiteX2" fmla="*/ 164306 w 500062"/>
                    <a:gd name="connsiteY2" fmla="*/ 42863 h 285750"/>
                    <a:gd name="connsiteX3" fmla="*/ 207168 w 500062"/>
                    <a:gd name="connsiteY3" fmla="*/ 28575 h 285750"/>
                    <a:gd name="connsiteX4" fmla="*/ 228600 w 500062"/>
                    <a:gd name="connsiteY4" fmla="*/ 14288 h 285750"/>
                    <a:gd name="connsiteX5" fmla="*/ 271462 w 500062"/>
                    <a:gd name="connsiteY5" fmla="*/ 0 h 285750"/>
                    <a:gd name="connsiteX6" fmla="*/ 371475 w 500062"/>
                    <a:gd name="connsiteY6" fmla="*/ 7144 h 285750"/>
                    <a:gd name="connsiteX7" fmla="*/ 414337 w 500062"/>
                    <a:gd name="connsiteY7" fmla="*/ 21431 h 285750"/>
                    <a:gd name="connsiteX8" fmla="*/ 457200 w 500062"/>
                    <a:gd name="connsiteY8" fmla="*/ 50006 h 285750"/>
                    <a:gd name="connsiteX9" fmla="*/ 478631 w 500062"/>
                    <a:gd name="connsiteY9" fmla="*/ 64294 h 285750"/>
                    <a:gd name="connsiteX10" fmla="*/ 500062 w 500062"/>
                    <a:gd name="connsiteY10" fmla="*/ 107156 h 285750"/>
                    <a:gd name="connsiteX11" fmla="*/ 492918 w 500062"/>
                    <a:gd name="connsiteY11" fmla="*/ 207169 h 285750"/>
                    <a:gd name="connsiteX12" fmla="*/ 478631 w 500062"/>
                    <a:gd name="connsiteY12" fmla="*/ 228600 h 285750"/>
                    <a:gd name="connsiteX13" fmla="*/ 414337 w 500062"/>
                    <a:gd name="connsiteY13" fmla="*/ 250031 h 285750"/>
                    <a:gd name="connsiteX14" fmla="*/ 392906 w 500062"/>
                    <a:gd name="connsiteY14" fmla="*/ 257175 h 285750"/>
                    <a:gd name="connsiteX15" fmla="*/ 371475 w 500062"/>
                    <a:gd name="connsiteY15" fmla="*/ 264319 h 285750"/>
                    <a:gd name="connsiteX16" fmla="*/ 235743 w 500062"/>
                    <a:gd name="connsiteY16" fmla="*/ 285750 h 285750"/>
                    <a:gd name="connsiteX17" fmla="*/ 121443 w 500062"/>
                    <a:gd name="connsiteY17" fmla="*/ 271463 h 285750"/>
                    <a:gd name="connsiteX18" fmla="*/ 57150 w 500062"/>
                    <a:gd name="connsiteY18" fmla="*/ 250031 h 285750"/>
                    <a:gd name="connsiteX19" fmla="*/ 35718 w 500062"/>
                    <a:gd name="connsiteY19" fmla="*/ 242888 h 285750"/>
                    <a:gd name="connsiteX20" fmla="*/ 14287 w 500062"/>
                    <a:gd name="connsiteY20" fmla="*/ 228600 h 285750"/>
                    <a:gd name="connsiteX21" fmla="*/ 0 w 500062"/>
                    <a:gd name="connsiteY21" fmla="*/ 185738 h 285750"/>
                    <a:gd name="connsiteX22" fmla="*/ 7143 w 500062"/>
                    <a:gd name="connsiteY22" fmla="*/ 128588 h 285750"/>
                    <a:gd name="connsiteX23" fmla="*/ 42862 w 500062"/>
                    <a:gd name="connsiteY23" fmla="*/ 92869 h 285750"/>
                    <a:gd name="connsiteX24" fmla="*/ 107156 w 500062"/>
                    <a:gd name="connsiteY24" fmla="*/ 64294 h 2857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</a:cxnLst>
                  <a:rect l="l" t="t" r="r" b="b"/>
                  <a:pathLst>
                    <a:path w="500062" h="285750">
                      <a:moveTo>
                        <a:pt x="107156" y="64294"/>
                      </a:moveTo>
                      <a:lnTo>
                        <a:pt x="107156" y="64294"/>
                      </a:lnTo>
                      <a:lnTo>
                        <a:pt x="164306" y="42863"/>
                      </a:lnTo>
                      <a:cubicBezTo>
                        <a:pt x="178489" y="37798"/>
                        <a:pt x="194637" y="36929"/>
                        <a:pt x="207168" y="28575"/>
                      </a:cubicBezTo>
                      <a:cubicBezTo>
                        <a:pt x="214312" y="23813"/>
                        <a:pt x="220754" y="17775"/>
                        <a:pt x="228600" y="14288"/>
                      </a:cubicBezTo>
                      <a:cubicBezTo>
                        <a:pt x="242362" y="8171"/>
                        <a:pt x="271462" y="0"/>
                        <a:pt x="271462" y="0"/>
                      </a:cubicBezTo>
                      <a:cubicBezTo>
                        <a:pt x="304800" y="2381"/>
                        <a:pt x="338422" y="2186"/>
                        <a:pt x="371475" y="7144"/>
                      </a:cubicBezTo>
                      <a:cubicBezTo>
                        <a:pt x="386369" y="9378"/>
                        <a:pt x="414337" y="21431"/>
                        <a:pt x="414337" y="21431"/>
                      </a:cubicBezTo>
                      <a:lnTo>
                        <a:pt x="457200" y="50006"/>
                      </a:lnTo>
                      <a:lnTo>
                        <a:pt x="478631" y="64294"/>
                      </a:lnTo>
                      <a:cubicBezTo>
                        <a:pt x="485854" y="75129"/>
                        <a:pt x="500062" y="92369"/>
                        <a:pt x="500062" y="107156"/>
                      </a:cubicBezTo>
                      <a:cubicBezTo>
                        <a:pt x="500062" y="140579"/>
                        <a:pt x="498726" y="174255"/>
                        <a:pt x="492918" y="207169"/>
                      </a:cubicBezTo>
                      <a:cubicBezTo>
                        <a:pt x="491426" y="215624"/>
                        <a:pt x="485912" y="224050"/>
                        <a:pt x="478631" y="228600"/>
                      </a:cubicBezTo>
                      <a:cubicBezTo>
                        <a:pt x="478623" y="228605"/>
                        <a:pt x="425058" y="246458"/>
                        <a:pt x="414337" y="250031"/>
                      </a:cubicBezTo>
                      <a:lnTo>
                        <a:pt x="392906" y="257175"/>
                      </a:lnTo>
                      <a:cubicBezTo>
                        <a:pt x="385762" y="259556"/>
                        <a:pt x="378903" y="263081"/>
                        <a:pt x="371475" y="264319"/>
                      </a:cubicBezTo>
                      <a:cubicBezTo>
                        <a:pt x="269141" y="281374"/>
                        <a:pt x="314428" y="274509"/>
                        <a:pt x="235743" y="285750"/>
                      </a:cubicBezTo>
                      <a:cubicBezTo>
                        <a:pt x="178261" y="280960"/>
                        <a:pt x="164816" y="284475"/>
                        <a:pt x="121443" y="271463"/>
                      </a:cubicBezTo>
                      <a:cubicBezTo>
                        <a:pt x="121423" y="271457"/>
                        <a:pt x="67876" y="253606"/>
                        <a:pt x="57150" y="250031"/>
                      </a:cubicBezTo>
                      <a:lnTo>
                        <a:pt x="35718" y="242888"/>
                      </a:lnTo>
                      <a:cubicBezTo>
                        <a:pt x="28574" y="238125"/>
                        <a:pt x="18837" y="235881"/>
                        <a:pt x="14287" y="228600"/>
                      </a:cubicBezTo>
                      <a:cubicBezTo>
                        <a:pt x="6305" y="215829"/>
                        <a:pt x="0" y="185738"/>
                        <a:pt x="0" y="185738"/>
                      </a:cubicBezTo>
                      <a:cubicBezTo>
                        <a:pt x="2381" y="166688"/>
                        <a:pt x="2092" y="147110"/>
                        <a:pt x="7143" y="128588"/>
                      </a:cubicBezTo>
                      <a:cubicBezTo>
                        <a:pt x="11413" y="112931"/>
                        <a:pt x="29067" y="99000"/>
                        <a:pt x="42862" y="92869"/>
                      </a:cubicBezTo>
                      <a:lnTo>
                        <a:pt x="107156" y="64294"/>
                      </a:lnTo>
                      <a:close/>
                    </a:path>
                  </a:pathLst>
                </a:custGeom>
                <a:solidFill>
                  <a:schemeClr val="accent2"/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  <p:sp>
              <p:nvSpPr>
                <p:cNvPr id="35" name="Oval 34">
                  <a:extLst>
                    <a:ext uri="{FF2B5EF4-FFF2-40B4-BE49-F238E27FC236}">
                      <a16:creationId xmlns:a16="http://schemas.microsoft.com/office/drawing/2014/main" id="{18F946EE-1189-1074-D771-E1828F4A98BA}"/>
                    </a:ext>
                  </a:extLst>
                </p:cNvPr>
                <p:cNvSpPr/>
                <p:nvPr/>
              </p:nvSpPr>
              <p:spPr>
                <a:xfrm>
                  <a:off x="3691518" y="3769051"/>
                  <a:ext cx="121444" cy="50006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1E687470-8C34-3E14-7DED-2AABE376E29D}"/>
                  </a:ext>
                </a:extLst>
              </p:cNvPr>
              <p:cNvGrpSpPr/>
              <p:nvPr/>
            </p:nvGrpSpPr>
            <p:grpSpPr>
              <a:xfrm>
                <a:off x="3649991" y="3865852"/>
                <a:ext cx="306461" cy="123091"/>
                <a:chOff x="3429000" y="3700462"/>
                <a:chExt cx="448256" cy="180043"/>
              </a:xfrm>
            </p:grpSpPr>
            <p:sp>
              <p:nvSpPr>
                <p:cNvPr id="32" name="Freeform 31">
                  <a:extLst>
                    <a:ext uri="{FF2B5EF4-FFF2-40B4-BE49-F238E27FC236}">
                      <a16:creationId xmlns:a16="http://schemas.microsoft.com/office/drawing/2014/main" id="{0D0F81C9-058B-CE8E-173C-1BF709CD5925}"/>
                    </a:ext>
                  </a:extLst>
                </p:cNvPr>
                <p:cNvSpPr/>
                <p:nvPr/>
              </p:nvSpPr>
              <p:spPr>
                <a:xfrm>
                  <a:off x="3429000" y="3700462"/>
                  <a:ext cx="448256" cy="180043"/>
                </a:xfrm>
                <a:custGeom>
                  <a:avLst/>
                  <a:gdLst>
                    <a:gd name="connsiteX0" fmla="*/ 107156 w 500062"/>
                    <a:gd name="connsiteY0" fmla="*/ 64294 h 285750"/>
                    <a:gd name="connsiteX1" fmla="*/ 107156 w 500062"/>
                    <a:gd name="connsiteY1" fmla="*/ 64294 h 285750"/>
                    <a:gd name="connsiteX2" fmla="*/ 164306 w 500062"/>
                    <a:gd name="connsiteY2" fmla="*/ 42863 h 285750"/>
                    <a:gd name="connsiteX3" fmla="*/ 207168 w 500062"/>
                    <a:gd name="connsiteY3" fmla="*/ 28575 h 285750"/>
                    <a:gd name="connsiteX4" fmla="*/ 228600 w 500062"/>
                    <a:gd name="connsiteY4" fmla="*/ 14288 h 285750"/>
                    <a:gd name="connsiteX5" fmla="*/ 271462 w 500062"/>
                    <a:gd name="connsiteY5" fmla="*/ 0 h 285750"/>
                    <a:gd name="connsiteX6" fmla="*/ 371475 w 500062"/>
                    <a:gd name="connsiteY6" fmla="*/ 7144 h 285750"/>
                    <a:gd name="connsiteX7" fmla="*/ 414337 w 500062"/>
                    <a:gd name="connsiteY7" fmla="*/ 21431 h 285750"/>
                    <a:gd name="connsiteX8" fmla="*/ 457200 w 500062"/>
                    <a:gd name="connsiteY8" fmla="*/ 50006 h 285750"/>
                    <a:gd name="connsiteX9" fmla="*/ 478631 w 500062"/>
                    <a:gd name="connsiteY9" fmla="*/ 64294 h 285750"/>
                    <a:gd name="connsiteX10" fmla="*/ 500062 w 500062"/>
                    <a:gd name="connsiteY10" fmla="*/ 107156 h 285750"/>
                    <a:gd name="connsiteX11" fmla="*/ 492918 w 500062"/>
                    <a:gd name="connsiteY11" fmla="*/ 207169 h 285750"/>
                    <a:gd name="connsiteX12" fmla="*/ 478631 w 500062"/>
                    <a:gd name="connsiteY12" fmla="*/ 228600 h 285750"/>
                    <a:gd name="connsiteX13" fmla="*/ 414337 w 500062"/>
                    <a:gd name="connsiteY13" fmla="*/ 250031 h 285750"/>
                    <a:gd name="connsiteX14" fmla="*/ 392906 w 500062"/>
                    <a:gd name="connsiteY14" fmla="*/ 257175 h 285750"/>
                    <a:gd name="connsiteX15" fmla="*/ 371475 w 500062"/>
                    <a:gd name="connsiteY15" fmla="*/ 264319 h 285750"/>
                    <a:gd name="connsiteX16" fmla="*/ 235743 w 500062"/>
                    <a:gd name="connsiteY16" fmla="*/ 285750 h 285750"/>
                    <a:gd name="connsiteX17" fmla="*/ 121443 w 500062"/>
                    <a:gd name="connsiteY17" fmla="*/ 271463 h 285750"/>
                    <a:gd name="connsiteX18" fmla="*/ 57150 w 500062"/>
                    <a:gd name="connsiteY18" fmla="*/ 250031 h 285750"/>
                    <a:gd name="connsiteX19" fmla="*/ 35718 w 500062"/>
                    <a:gd name="connsiteY19" fmla="*/ 242888 h 285750"/>
                    <a:gd name="connsiteX20" fmla="*/ 14287 w 500062"/>
                    <a:gd name="connsiteY20" fmla="*/ 228600 h 285750"/>
                    <a:gd name="connsiteX21" fmla="*/ 0 w 500062"/>
                    <a:gd name="connsiteY21" fmla="*/ 185738 h 285750"/>
                    <a:gd name="connsiteX22" fmla="*/ 7143 w 500062"/>
                    <a:gd name="connsiteY22" fmla="*/ 128588 h 285750"/>
                    <a:gd name="connsiteX23" fmla="*/ 42862 w 500062"/>
                    <a:gd name="connsiteY23" fmla="*/ 92869 h 285750"/>
                    <a:gd name="connsiteX24" fmla="*/ 107156 w 500062"/>
                    <a:gd name="connsiteY24" fmla="*/ 64294 h 2857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</a:cxnLst>
                  <a:rect l="l" t="t" r="r" b="b"/>
                  <a:pathLst>
                    <a:path w="500062" h="285750">
                      <a:moveTo>
                        <a:pt x="107156" y="64294"/>
                      </a:moveTo>
                      <a:lnTo>
                        <a:pt x="107156" y="64294"/>
                      </a:lnTo>
                      <a:lnTo>
                        <a:pt x="164306" y="42863"/>
                      </a:lnTo>
                      <a:cubicBezTo>
                        <a:pt x="178489" y="37798"/>
                        <a:pt x="194637" y="36929"/>
                        <a:pt x="207168" y="28575"/>
                      </a:cubicBezTo>
                      <a:cubicBezTo>
                        <a:pt x="214312" y="23813"/>
                        <a:pt x="220754" y="17775"/>
                        <a:pt x="228600" y="14288"/>
                      </a:cubicBezTo>
                      <a:cubicBezTo>
                        <a:pt x="242362" y="8171"/>
                        <a:pt x="271462" y="0"/>
                        <a:pt x="271462" y="0"/>
                      </a:cubicBezTo>
                      <a:cubicBezTo>
                        <a:pt x="304800" y="2381"/>
                        <a:pt x="338422" y="2186"/>
                        <a:pt x="371475" y="7144"/>
                      </a:cubicBezTo>
                      <a:cubicBezTo>
                        <a:pt x="386369" y="9378"/>
                        <a:pt x="414337" y="21431"/>
                        <a:pt x="414337" y="21431"/>
                      </a:cubicBezTo>
                      <a:lnTo>
                        <a:pt x="457200" y="50006"/>
                      </a:lnTo>
                      <a:lnTo>
                        <a:pt x="478631" y="64294"/>
                      </a:lnTo>
                      <a:cubicBezTo>
                        <a:pt x="485854" y="75129"/>
                        <a:pt x="500062" y="92369"/>
                        <a:pt x="500062" y="107156"/>
                      </a:cubicBezTo>
                      <a:cubicBezTo>
                        <a:pt x="500062" y="140579"/>
                        <a:pt x="498726" y="174255"/>
                        <a:pt x="492918" y="207169"/>
                      </a:cubicBezTo>
                      <a:cubicBezTo>
                        <a:pt x="491426" y="215624"/>
                        <a:pt x="485912" y="224050"/>
                        <a:pt x="478631" y="228600"/>
                      </a:cubicBezTo>
                      <a:cubicBezTo>
                        <a:pt x="478623" y="228605"/>
                        <a:pt x="425058" y="246458"/>
                        <a:pt x="414337" y="250031"/>
                      </a:cubicBezTo>
                      <a:lnTo>
                        <a:pt x="392906" y="257175"/>
                      </a:lnTo>
                      <a:cubicBezTo>
                        <a:pt x="385762" y="259556"/>
                        <a:pt x="378903" y="263081"/>
                        <a:pt x="371475" y="264319"/>
                      </a:cubicBezTo>
                      <a:cubicBezTo>
                        <a:pt x="269141" y="281374"/>
                        <a:pt x="314428" y="274509"/>
                        <a:pt x="235743" y="285750"/>
                      </a:cubicBezTo>
                      <a:cubicBezTo>
                        <a:pt x="178261" y="280960"/>
                        <a:pt x="164816" y="284475"/>
                        <a:pt x="121443" y="271463"/>
                      </a:cubicBezTo>
                      <a:cubicBezTo>
                        <a:pt x="121423" y="271457"/>
                        <a:pt x="67876" y="253606"/>
                        <a:pt x="57150" y="250031"/>
                      </a:cubicBezTo>
                      <a:lnTo>
                        <a:pt x="35718" y="242888"/>
                      </a:lnTo>
                      <a:cubicBezTo>
                        <a:pt x="28574" y="238125"/>
                        <a:pt x="18837" y="235881"/>
                        <a:pt x="14287" y="228600"/>
                      </a:cubicBezTo>
                      <a:cubicBezTo>
                        <a:pt x="6305" y="215829"/>
                        <a:pt x="0" y="185738"/>
                        <a:pt x="0" y="185738"/>
                      </a:cubicBezTo>
                      <a:cubicBezTo>
                        <a:pt x="2381" y="166688"/>
                        <a:pt x="2092" y="147110"/>
                        <a:pt x="7143" y="128588"/>
                      </a:cubicBezTo>
                      <a:cubicBezTo>
                        <a:pt x="11413" y="112931"/>
                        <a:pt x="29067" y="99000"/>
                        <a:pt x="42862" y="92869"/>
                      </a:cubicBezTo>
                      <a:lnTo>
                        <a:pt x="107156" y="64294"/>
                      </a:lnTo>
                      <a:close/>
                    </a:path>
                  </a:pathLst>
                </a:custGeom>
                <a:solidFill>
                  <a:schemeClr val="accent2"/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  <p:sp>
              <p:nvSpPr>
                <p:cNvPr id="33" name="Oval 32">
                  <a:extLst>
                    <a:ext uri="{FF2B5EF4-FFF2-40B4-BE49-F238E27FC236}">
                      <a16:creationId xmlns:a16="http://schemas.microsoft.com/office/drawing/2014/main" id="{F20696F7-7BBE-88D7-F9C8-773232C4F186}"/>
                    </a:ext>
                  </a:extLst>
                </p:cNvPr>
                <p:cNvSpPr/>
                <p:nvPr/>
              </p:nvSpPr>
              <p:spPr>
                <a:xfrm>
                  <a:off x="3691518" y="3769051"/>
                  <a:ext cx="121444" cy="50006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29" name="Group 28">
                <a:extLst>
                  <a:ext uri="{FF2B5EF4-FFF2-40B4-BE49-F238E27FC236}">
                    <a16:creationId xmlns:a16="http://schemas.microsoft.com/office/drawing/2014/main" id="{0750EB0A-A3B6-B8ED-5DA1-6C474E6585E6}"/>
                  </a:ext>
                </a:extLst>
              </p:cNvPr>
              <p:cNvGrpSpPr/>
              <p:nvPr/>
            </p:nvGrpSpPr>
            <p:grpSpPr>
              <a:xfrm>
                <a:off x="3759265" y="3729082"/>
                <a:ext cx="306461" cy="123091"/>
                <a:chOff x="3429000" y="3700462"/>
                <a:chExt cx="448256" cy="180043"/>
              </a:xfrm>
            </p:grpSpPr>
            <p:sp>
              <p:nvSpPr>
                <p:cNvPr id="30" name="Freeform 29">
                  <a:extLst>
                    <a:ext uri="{FF2B5EF4-FFF2-40B4-BE49-F238E27FC236}">
                      <a16:creationId xmlns:a16="http://schemas.microsoft.com/office/drawing/2014/main" id="{FAE7A4AF-41DE-13D1-62F9-E61175E6C3B8}"/>
                    </a:ext>
                  </a:extLst>
                </p:cNvPr>
                <p:cNvSpPr/>
                <p:nvPr/>
              </p:nvSpPr>
              <p:spPr>
                <a:xfrm>
                  <a:off x="3429000" y="3700462"/>
                  <a:ext cx="448256" cy="180043"/>
                </a:xfrm>
                <a:custGeom>
                  <a:avLst/>
                  <a:gdLst>
                    <a:gd name="connsiteX0" fmla="*/ 107156 w 500062"/>
                    <a:gd name="connsiteY0" fmla="*/ 64294 h 285750"/>
                    <a:gd name="connsiteX1" fmla="*/ 107156 w 500062"/>
                    <a:gd name="connsiteY1" fmla="*/ 64294 h 285750"/>
                    <a:gd name="connsiteX2" fmla="*/ 164306 w 500062"/>
                    <a:gd name="connsiteY2" fmla="*/ 42863 h 285750"/>
                    <a:gd name="connsiteX3" fmla="*/ 207168 w 500062"/>
                    <a:gd name="connsiteY3" fmla="*/ 28575 h 285750"/>
                    <a:gd name="connsiteX4" fmla="*/ 228600 w 500062"/>
                    <a:gd name="connsiteY4" fmla="*/ 14288 h 285750"/>
                    <a:gd name="connsiteX5" fmla="*/ 271462 w 500062"/>
                    <a:gd name="connsiteY5" fmla="*/ 0 h 285750"/>
                    <a:gd name="connsiteX6" fmla="*/ 371475 w 500062"/>
                    <a:gd name="connsiteY6" fmla="*/ 7144 h 285750"/>
                    <a:gd name="connsiteX7" fmla="*/ 414337 w 500062"/>
                    <a:gd name="connsiteY7" fmla="*/ 21431 h 285750"/>
                    <a:gd name="connsiteX8" fmla="*/ 457200 w 500062"/>
                    <a:gd name="connsiteY8" fmla="*/ 50006 h 285750"/>
                    <a:gd name="connsiteX9" fmla="*/ 478631 w 500062"/>
                    <a:gd name="connsiteY9" fmla="*/ 64294 h 285750"/>
                    <a:gd name="connsiteX10" fmla="*/ 500062 w 500062"/>
                    <a:gd name="connsiteY10" fmla="*/ 107156 h 285750"/>
                    <a:gd name="connsiteX11" fmla="*/ 492918 w 500062"/>
                    <a:gd name="connsiteY11" fmla="*/ 207169 h 285750"/>
                    <a:gd name="connsiteX12" fmla="*/ 478631 w 500062"/>
                    <a:gd name="connsiteY12" fmla="*/ 228600 h 285750"/>
                    <a:gd name="connsiteX13" fmla="*/ 414337 w 500062"/>
                    <a:gd name="connsiteY13" fmla="*/ 250031 h 285750"/>
                    <a:gd name="connsiteX14" fmla="*/ 392906 w 500062"/>
                    <a:gd name="connsiteY14" fmla="*/ 257175 h 285750"/>
                    <a:gd name="connsiteX15" fmla="*/ 371475 w 500062"/>
                    <a:gd name="connsiteY15" fmla="*/ 264319 h 285750"/>
                    <a:gd name="connsiteX16" fmla="*/ 235743 w 500062"/>
                    <a:gd name="connsiteY16" fmla="*/ 285750 h 285750"/>
                    <a:gd name="connsiteX17" fmla="*/ 121443 w 500062"/>
                    <a:gd name="connsiteY17" fmla="*/ 271463 h 285750"/>
                    <a:gd name="connsiteX18" fmla="*/ 57150 w 500062"/>
                    <a:gd name="connsiteY18" fmla="*/ 250031 h 285750"/>
                    <a:gd name="connsiteX19" fmla="*/ 35718 w 500062"/>
                    <a:gd name="connsiteY19" fmla="*/ 242888 h 285750"/>
                    <a:gd name="connsiteX20" fmla="*/ 14287 w 500062"/>
                    <a:gd name="connsiteY20" fmla="*/ 228600 h 285750"/>
                    <a:gd name="connsiteX21" fmla="*/ 0 w 500062"/>
                    <a:gd name="connsiteY21" fmla="*/ 185738 h 285750"/>
                    <a:gd name="connsiteX22" fmla="*/ 7143 w 500062"/>
                    <a:gd name="connsiteY22" fmla="*/ 128588 h 285750"/>
                    <a:gd name="connsiteX23" fmla="*/ 42862 w 500062"/>
                    <a:gd name="connsiteY23" fmla="*/ 92869 h 285750"/>
                    <a:gd name="connsiteX24" fmla="*/ 107156 w 500062"/>
                    <a:gd name="connsiteY24" fmla="*/ 64294 h 2857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</a:cxnLst>
                  <a:rect l="l" t="t" r="r" b="b"/>
                  <a:pathLst>
                    <a:path w="500062" h="285750">
                      <a:moveTo>
                        <a:pt x="107156" y="64294"/>
                      </a:moveTo>
                      <a:lnTo>
                        <a:pt x="107156" y="64294"/>
                      </a:lnTo>
                      <a:lnTo>
                        <a:pt x="164306" y="42863"/>
                      </a:lnTo>
                      <a:cubicBezTo>
                        <a:pt x="178489" y="37798"/>
                        <a:pt x="194637" y="36929"/>
                        <a:pt x="207168" y="28575"/>
                      </a:cubicBezTo>
                      <a:cubicBezTo>
                        <a:pt x="214312" y="23813"/>
                        <a:pt x="220754" y="17775"/>
                        <a:pt x="228600" y="14288"/>
                      </a:cubicBezTo>
                      <a:cubicBezTo>
                        <a:pt x="242362" y="8171"/>
                        <a:pt x="271462" y="0"/>
                        <a:pt x="271462" y="0"/>
                      </a:cubicBezTo>
                      <a:cubicBezTo>
                        <a:pt x="304800" y="2381"/>
                        <a:pt x="338422" y="2186"/>
                        <a:pt x="371475" y="7144"/>
                      </a:cubicBezTo>
                      <a:cubicBezTo>
                        <a:pt x="386369" y="9378"/>
                        <a:pt x="414337" y="21431"/>
                        <a:pt x="414337" y="21431"/>
                      </a:cubicBezTo>
                      <a:lnTo>
                        <a:pt x="457200" y="50006"/>
                      </a:lnTo>
                      <a:lnTo>
                        <a:pt x="478631" y="64294"/>
                      </a:lnTo>
                      <a:cubicBezTo>
                        <a:pt x="485854" y="75129"/>
                        <a:pt x="500062" y="92369"/>
                        <a:pt x="500062" y="107156"/>
                      </a:cubicBezTo>
                      <a:cubicBezTo>
                        <a:pt x="500062" y="140579"/>
                        <a:pt x="498726" y="174255"/>
                        <a:pt x="492918" y="207169"/>
                      </a:cubicBezTo>
                      <a:cubicBezTo>
                        <a:pt x="491426" y="215624"/>
                        <a:pt x="485912" y="224050"/>
                        <a:pt x="478631" y="228600"/>
                      </a:cubicBezTo>
                      <a:cubicBezTo>
                        <a:pt x="478623" y="228605"/>
                        <a:pt x="425058" y="246458"/>
                        <a:pt x="414337" y="250031"/>
                      </a:cubicBezTo>
                      <a:lnTo>
                        <a:pt x="392906" y="257175"/>
                      </a:lnTo>
                      <a:cubicBezTo>
                        <a:pt x="385762" y="259556"/>
                        <a:pt x="378903" y="263081"/>
                        <a:pt x="371475" y="264319"/>
                      </a:cubicBezTo>
                      <a:cubicBezTo>
                        <a:pt x="269141" y="281374"/>
                        <a:pt x="314428" y="274509"/>
                        <a:pt x="235743" y="285750"/>
                      </a:cubicBezTo>
                      <a:cubicBezTo>
                        <a:pt x="178261" y="280960"/>
                        <a:pt x="164816" y="284475"/>
                        <a:pt x="121443" y="271463"/>
                      </a:cubicBezTo>
                      <a:cubicBezTo>
                        <a:pt x="121423" y="271457"/>
                        <a:pt x="67876" y="253606"/>
                        <a:pt x="57150" y="250031"/>
                      </a:cubicBezTo>
                      <a:lnTo>
                        <a:pt x="35718" y="242888"/>
                      </a:lnTo>
                      <a:cubicBezTo>
                        <a:pt x="28574" y="238125"/>
                        <a:pt x="18837" y="235881"/>
                        <a:pt x="14287" y="228600"/>
                      </a:cubicBezTo>
                      <a:cubicBezTo>
                        <a:pt x="6305" y="215829"/>
                        <a:pt x="0" y="185738"/>
                        <a:pt x="0" y="185738"/>
                      </a:cubicBezTo>
                      <a:cubicBezTo>
                        <a:pt x="2381" y="166688"/>
                        <a:pt x="2092" y="147110"/>
                        <a:pt x="7143" y="128588"/>
                      </a:cubicBezTo>
                      <a:cubicBezTo>
                        <a:pt x="11413" y="112931"/>
                        <a:pt x="29067" y="99000"/>
                        <a:pt x="42862" y="92869"/>
                      </a:cubicBezTo>
                      <a:lnTo>
                        <a:pt x="107156" y="64294"/>
                      </a:lnTo>
                      <a:close/>
                    </a:path>
                  </a:pathLst>
                </a:custGeom>
                <a:solidFill>
                  <a:schemeClr val="accent2"/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  <p:sp>
              <p:nvSpPr>
                <p:cNvPr id="31" name="Oval 30">
                  <a:extLst>
                    <a:ext uri="{FF2B5EF4-FFF2-40B4-BE49-F238E27FC236}">
                      <a16:creationId xmlns:a16="http://schemas.microsoft.com/office/drawing/2014/main" id="{42772C8D-1BA1-04FF-92AB-F91B7949E46D}"/>
                    </a:ext>
                  </a:extLst>
                </p:cNvPr>
                <p:cNvSpPr/>
                <p:nvPr/>
              </p:nvSpPr>
              <p:spPr>
                <a:xfrm>
                  <a:off x="3691518" y="3769051"/>
                  <a:ext cx="121444" cy="50006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</p:grp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A713BA0A-9A72-2EC6-10AD-747D142A0B71}"/>
                </a:ext>
              </a:extLst>
            </p:cNvPr>
            <p:cNvGrpSpPr/>
            <p:nvPr/>
          </p:nvGrpSpPr>
          <p:grpSpPr>
            <a:xfrm>
              <a:off x="1768549" y="3355598"/>
              <a:ext cx="470314" cy="197102"/>
              <a:chOff x="3445660" y="3729082"/>
              <a:chExt cx="620066" cy="259861"/>
            </a:xfrm>
          </p:grpSpPr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9E5A45ED-FF47-76B3-9CDE-5C982EAF85A6}"/>
                  </a:ext>
                </a:extLst>
              </p:cNvPr>
              <p:cNvGrpSpPr/>
              <p:nvPr/>
            </p:nvGrpSpPr>
            <p:grpSpPr>
              <a:xfrm>
                <a:off x="3445660" y="3768831"/>
                <a:ext cx="306461" cy="123091"/>
                <a:chOff x="3429000" y="3700462"/>
                <a:chExt cx="448256" cy="180043"/>
              </a:xfrm>
            </p:grpSpPr>
            <p:sp>
              <p:nvSpPr>
                <p:cNvPr id="25" name="Freeform 24">
                  <a:extLst>
                    <a:ext uri="{FF2B5EF4-FFF2-40B4-BE49-F238E27FC236}">
                      <a16:creationId xmlns:a16="http://schemas.microsoft.com/office/drawing/2014/main" id="{40717251-93B6-956C-ED67-13A6BA8952EE}"/>
                    </a:ext>
                  </a:extLst>
                </p:cNvPr>
                <p:cNvSpPr/>
                <p:nvPr/>
              </p:nvSpPr>
              <p:spPr>
                <a:xfrm>
                  <a:off x="3429000" y="3700462"/>
                  <a:ext cx="448256" cy="180043"/>
                </a:xfrm>
                <a:custGeom>
                  <a:avLst/>
                  <a:gdLst>
                    <a:gd name="connsiteX0" fmla="*/ 107156 w 500062"/>
                    <a:gd name="connsiteY0" fmla="*/ 64294 h 285750"/>
                    <a:gd name="connsiteX1" fmla="*/ 107156 w 500062"/>
                    <a:gd name="connsiteY1" fmla="*/ 64294 h 285750"/>
                    <a:gd name="connsiteX2" fmla="*/ 164306 w 500062"/>
                    <a:gd name="connsiteY2" fmla="*/ 42863 h 285750"/>
                    <a:gd name="connsiteX3" fmla="*/ 207168 w 500062"/>
                    <a:gd name="connsiteY3" fmla="*/ 28575 h 285750"/>
                    <a:gd name="connsiteX4" fmla="*/ 228600 w 500062"/>
                    <a:gd name="connsiteY4" fmla="*/ 14288 h 285750"/>
                    <a:gd name="connsiteX5" fmla="*/ 271462 w 500062"/>
                    <a:gd name="connsiteY5" fmla="*/ 0 h 285750"/>
                    <a:gd name="connsiteX6" fmla="*/ 371475 w 500062"/>
                    <a:gd name="connsiteY6" fmla="*/ 7144 h 285750"/>
                    <a:gd name="connsiteX7" fmla="*/ 414337 w 500062"/>
                    <a:gd name="connsiteY7" fmla="*/ 21431 h 285750"/>
                    <a:gd name="connsiteX8" fmla="*/ 457200 w 500062"/>
                    <a:gd name="connsiteY8" fmla="*/ 50006 h 285750"/>
                    <a:gd name="connsiteX9" fmla="*/ 478631 w 500062"/>
                    <a:gd name="connsiteY9" fmla="*/ 64294 h 285750"/>
                    <a:gd name="connsiteX10" fmla="*/ 500062 w 500062"/>
                    <a:gd name="connsiteY10" fmla="*/ 107156 h 285750"/>
                    <a:gd name="connsiteX11" fmla="*/ 492918 w 500062"/>
                    <a:gd name="connsiteY11" fmla="*/ 207169 h 285750"/>
                    <a:gd name="connsiteX12" fmla="*/ 478631 w 500062"/>
                    <a:gd name="connsiteY12" fmla="*/ 228600 h 285750"/>
                    <a:gd name="connsiteX13" fmla="*/ 414337 w 500062"/>
                    <a:gd name="connsiteY13" fmla="*/ 250031 h 285750"/>
                    <a:gd name="connsiteX14" fmla="*/ 392906 w 500062"/>
                    <a:gd name="connsiteY14" fmla="*/ 257175 h 285750"/>
                    <a:gd name="connsiteX15" fmla="*/ 371475 w 500062"/>
                    <a:gd name="connsiteY15" fmla="*/ 264319 h 285750"/>
                    <a:gd name="connsiteX16" fmla="*/ 235743 w 500062"/>
                    <a:gd name="connsiteY16" fmla="*/ 285750 h 285750"/>
                    <a:gd name="connsiteX17" fmla="*/ 121443 w 500062"/>
                    <a:gd name="connsiteY17" fmla="*/ 271463 h 285750"/>
                    <a:gd name="connsiteX18" fmla="*/ 57150 w 500062"/>
                    <a:gd name="connsiteY18" fmla="*/ 250031 h 285750"/>
                    <a:gd name="connsiteX19" fmla="*/ 35718 w 500062"/>
                    <a:gd name="connsiteY19" fmla="*/ 242888 h 285750"/>
                    <a:gd name="connsiteX20" fmla="*/ 14287 w 500062"/>
                    <a:gd name="connsiteY20" fmla="*/ 228600 h 285750"/>
                    <a:gd name="connsiteX21" fmla="*/ 0 w 500062"/>
                    <a:gd name="connsiteY21" fmla="*/ 185738 h 285750"/>
                    <a:gd name="connsiteX22" fmla="*/ 7143 w 500062"/>
                    <a:gd name="connsiteY22" fmla="*/ 128588 h 285750"/>
                    <a:gd name="connsiteX23" fmla="*/ 42862 w 500062"/>
                    <a:gd name="connsiteY23" fmla="*/ 92869 h 285750"/>
                    <a:gd name="connsiteX24" fmla="*/ 107156 w 500062"/>
                    <a:gd name="connsiteY24" fmla="*/ 64294 h 2857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</a:cxnLst>
                  <a:rect l="l" t="t" r="r" b="b"/>
                  <a:pathLst>
                    <a:path w="500062" h="285750">
                      <a:moveTo>
                        <a:pt x="107156" y="64294"/>
                      </a:moveTo>
                      <a:lnTo>
                        <a:pt x="107156" y="64294"/>
                      </a:lnTo>
                      <a:lnTo>
                        <a:pt x="164306" y="42863"/>
                      </a:lnTo>
                      <a:cubicBezTo>
                        <a:pt x="178489" y="37798"/>
                        <a:pt x="194637" y="36929"/>
                        <a:pt x="207168" y="28575"/>
                      </a:cubicBezTo>
                      <a:cubicBezTo>
                        <a:pt x="214312" y="23813"/>
                        <a:pt x="220754" y="17775"/>
                        <a:pt x="228600" y="14288"/>
                      </a:cubicBezTo>
                      <a:cubicBezTo>
                        <a:pt x="242362" y="8171"/>
                        <a:pt x="271462" y="0"/>
                        <a:pt x="271462" y="0"/>
                      </a:cubicBezTo>
                      <a:cubicBezTo>
                        <a:pt x="304800" y="2381"/>
                        <a:pt x="338422" y="2186"/>
                        <a:pt x="371475" y="7144"/>
                      </a:cubicBezTo>
                      <a:cubicBezTo>
                        <a:pt x="386369" y="9378"/>
                        <a:pt x="414337" y="21431"/>
                        <a:pt x="414337" y="21431"/>
                      </a:cubicBezTo>
                      <a:lnTo>
                        <a:pt x="457200" y="50006"/>
                      </a:lnTo>
                      <a:lnTo>
                        <a:pt x="478631" y="64294"/>
                      </a:lnTo>
                      <a:cubicBezTo>
                        <a:pt x="485854" y="75129"/>
                        <a:pt x="500062" y="92369"/>
                        <a:pt x="500062" y="107156"/>
                      </a:cubicBezTo>
                      <a:cubicBezTo>
                        <a:pt x="500062" y="140579"/>
                        <a:pt x="498726" y="174255"/>
                        <a:pt x="492918" y="207169"/>
                      </a:cubicBezTo>
                      <a:cubicBezTo>
                        <a:pt x="491426" y="215624"/>
                        <a:pt x="485912" y="224050"/>
                        <a:pt x="478631" y="228600"/>
                      </a:cubicBezTo>
                      <a:cubicBezTo>
                        <a:pt x="478623" y="228605"/>
                        <a:pt x="425058" y="246458"/>
                        <a:pt x="414337" y="250031"/>
                      </a:cubicBezTo>
                      <a:lnTo>
                        <a:pt x="392906" y="257175"/>
                      </a:lnTo>
                      <a:cubicBezTo>
                        <a:pt x="385762" y="259556"/>
                        <a:pt x="378903" y="263081"/>
                        <a:pt x="371475" y="264319"/>
                      </a:cubicBezTo>
                      <a:cubicBezTo>
                        <a:pt x="269141" y="281374"/>
                        <a:pt x="314428" y="274509"/>
                        <a:pt x="235743" y="285750"/>
                      </a:cubicBezTo>
                      <a:cubicBezTo>
                        <a:pt x="178261" y="280960"/>
                        <a:pt x="164816" y="284475"/>
                        <a:pt x="121443" y="271463"/>
                      </a:cubicBezTo>
                      <a:cubicBezTo>
                        <a:pt x="121423" y="271457"/>
                        <a:pt x="67876" y="253606"/>
                        <a:pt x="57150" y="250031"/>
                      </a:cubicBezTo>
                      <a:lnTo>
                        <a:pt x="35718" y="242888"/>
                      </a:lnTo>
                      <a:cubicBezTo>
                        <a:pt x="28574" y="238125"/>
                        <a:pt x="18837" y="235881"/>
                        <a:pt x="14287" y="228600"/>
                      </a:cubicBezTo>
                      <a:cubicBezTo>
                        <a:pt x="6305" y="215829"/>
                        <a:pt x="0" y="185738"/>
                        <a:pt x="0" y="185738"/>
                      </a:cubicBezTo>
                      <a:cubicBezTo>
                        <a:pt x="2381" y="166688"/>
                        <a:pt x="2092" y="147110"/>
                        <a:pt x="7143" y="128588"/>
                      </a:cubicBezTo>
                      <a:cubicBezTo>
                        <a:pt x="11413" y="112931"/>
                        <a:pt x="29067" y="99000"/>
                        <a:pt x="42862" y="92869"/>
                      </a:cubicBezTo>
                      <a:lnTo>
                        <a:pt x="107156" y="64294"/>
                      </a:lnTo>
                      <a:close/>
                    </a:path>
                  </a:pathLst>
                </a:custGeom>
                <a:solidFill>
                  <a:schemeClr val="accent2"/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  <p:sp>
              <p:nvSpPr>
                <p:cNvPr id="26" name="Oval 25">
                  <a:extLst>
                    <a:ext uri="{FF2B5EF4-FFF2-40B4-BE49-F238E27FC236}">
                      <a16:creationId xmlns:a16="http://schemas.microsoft.com/office/drawing/2014/main" id="{533E5D99-C3AD-8CA4-E8E1-AC615479C550}"/>
                    </a:ext>
                  </a:extLst>
                </p:cNvPr>
                <p:cNvSpPr/>
                <p:nvPr/>
              </p:nvSpPr>
              <p:spPr>
                <a:xfrm>
                  <a:off x="3691518" y="3769051"/>
                  <a:ext cx="121444" cy="50006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8623492D-4B2A-3DB7-3CB0-C3F2A7F36D5B}"/>
                  </a:ext>
                </a:extLst>
              </p:cNvPr>
              <p:cNvGrpSpPr/>
              <p:nvPr/>
            </p:nvGrpSpPr>
            <p:grpSpPr>
              <a:xfrm>
                <a:off x="3649991" y="3865852"/>
                <a:ext cx="306461" cy="123091"/>
                <a:chOff x="3429000" y="3700462"/>
                <a:chExt cx="448256" cy="180043"/>
              </a:xfrm>
            </p:grpSpPr>
            <p:sp>
              <p:nvSpPr>
                <p:cNvPr id="23" name="Freeform 22">
                  <a:extLst>
                    <a:ext uri="{FF2B5EF4-FFF2-40B4-BE49-F238E27FC236}">
                      <a16:creationId xmlns:a16="http://schemas.microsoft.com/office/drawing/2014/main" id="{D29E87F0-7632-5B3A-09DD-A3C2E9143C9B}"/>
                    </a:ext>
                  </a:extLst>
                </p:cNvPr>
                <p:cNvSpPr/>
                <p:nvPr/>
              </p:nvSpPr>
              <p:spPr>
                <a:xfrm>
                  <a:off x="3429000" y="3700462"/>
                  <a:ext cx="448256" cy="180043"/>
                </a:xfrm>
                <a:custGeom>
                  <a:avLst/>
                  <a:gdLst>
                    <a:gd name="connsiteX0" fmla="*/ 107156 w 500062"/>
                    <a:gd name="connsiteY0" fmla="*/ 64294 h 285750"/>
                    <a:gd name="connsiteX1" fmla="*/ 107156 w 500062"/>
                    <a:gd name="connsiteY1" fmla="*/ 64294 h 285750"/>
                    <a:gd name="connsiteX2" fmla="*/ 164306 w 500062"/>
                    <a:gd name="connsiteY2" fmla="*/ 42863 h 285750"/>
                    <a:gd name="connsiteX3" fmla="*/ 207168 w 500062"/>
                    <a:gd name="connsiteY3" fmla="*/ 28575 h 285750"/>
                    <a:gd name="connsiteX4" fmla="*/ 228600 w 500062"/>
                    <a:gd name="connsiteY4" fmla="*/ 14288 h 285750"/>
                    <a:gd name="connsiteX5" fmla="*/ 271462 w 500062"/>
                    <a:gd name="connsiteY5" fmla="*/ 0 h 285750"/>
                    <a:gd name="connsiteX6" fmla="*/ 371475 w 500062"/>
                    <a:gd name="connsiteY6" fmla="*/ 7144 h 285750"/>
                    <a:gd name="connsiteX7" fmla="*/ 414337 w 500062"/>
                    <a:gd name="connsiteY7" fmla="*/ 21431 h 285750"/>
                    <a:gd name="connsiteX8" fmla="*/ 457200 w 500062"/>
                    <a:gd name="connsiteY8" fmla="*/ 50006 h 285750"/>
                    <a:gd name="connsiteX9" fmla="*/ 478631 w 500062"/>
                    <a:gd name="connsiteY9" fmla="*/ 64294 h 285750"/>
                    <a:gd name="connsiteX10" fmla="*/ 500062 w 500062"/>
                    <a:gd name="connsiteY10" fmla="*/ 107156 h 285750"/>
                    <a:gd name="connsiteX11" fmla="*/ 492918 w 500062"/>
                    <a:gd name="connsiteY11" fmla="*/ 207169 h 285750"/>
                    <a:gd name="connsiteX12" fmla="*/ 478631 w 500062"/>
                    <a:gd name="connsiteY12" fmla="*/ 228600 h 285750"/>
                    <a:gd name="connsiteX13" fmla="*/ 414337 w 500062"/>
                    <a:gd name="connsiteY13" fmla="*/ 250031 h 285750"/>
                    <a:gd name="connsiteX14" fmla="*/ 392906 w 500062"/>
                    <a:gd name="connsiteY14" fmla="*/ 257175 h 285750"/>
                    <a:gd name="connsiteX15" fmla="*/ 371475 w 500062"/>
                    <a:gd name="connsiteY15" fmla="*/ 264319 h 285750"/>
                    <a:gd name="connsiteX16" fmla="*/ 235743 w 500062"/>
                    <a:gd name="connsiteY16" fmla="*/ 285750 h 285750"/>
                    <a:gd name="connsiteX17" fmla="*/ 121443 w 500062"/>
                    <a:gd name="connsiteY17" fmla="*/ 271463 h 285750"/>
                    <a:gd name="connsiteX18" fmla="*/ 57150 w 500062"/>
                    <a:gd name="connsiteY18" fmla="*/ 250031 h 285750"/>
                    <a:gd name="connsiteX19" fmla="*/ 35718 w 500062"/>
                    <a:gd name="connsiteY19" fmla="*/ 242888 h 285750"/>
                    <a:gd name="connsiteX20" fmla="*/ 14287 w 500062"/>
                    <a:gd name="connsiteY20" fmla="*/ 228600 h 285750"/>
                    <a:gd name="connsiteX21" fmla="*/ 0 w 500062"/>
                    <a:gd name="connsiteY21" fmla="*/ 185738 h 285750"/>
                    <a:gd name="connsiteX22" fmla="*/ 7143 w 500062"/>
                    <a:gd name="connsiteY22" fmla="*/ 128588 h 285750"/>
                    <a:gd name="connsiteX23" fmla="*/ 42862 w 500062"/>
                    <a:gd name="connsiteY23" fmla="*/ 92869 h 285750"/>
                    <a:gd name="connsiteX24" fmla="*/ 107156 w 500062"/>
                    <a:gd name="connsiteY24" fmla="*/ 64294 h 2857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</a:cxnLst>
                  <a:rect l="l" t="t" r="r" b="b"/>
                  <a:pathLst>
                    <a:path w="500062" h="285750">
                      <a:moveTo>
                        <a:pt x="107156" y="64294"/>
                      </a:moveTo>
                      <a:lnTo>
                        <a:pt x="107156" y="64294"/>
                      </a:lnTo>
                      <a:lnTo>
                        <a:pt x="164306" y="42863"/>
                      </a:lnTo>
                      <a:cubicBezTo>
                        <a:pt x="178489" y="37798"/>
                        <a:pt x="194637" y="36929"/>
                        <a:pt x="207168" y="28575"/>
                      </a:cubicBezTo>
                      <a:cubicBezTo>
                        <a:pt x="214312" y="23813"/>
                        <a:pt x="220754" y="17775"/>
                        <a:pt x="228600" y="14288"/>
                      </a:cubicBezTo>
                      <a:cubicBezTo>
                        <a:pt x="242362" y="8171"/>
                        <a:pt x="271462" y="0"/>
                        <a:pt x="271462" y="0"/>
                      </a:cubicBezTo>
                      <a:cubicBezTo>
                        <a:pt x="304800" y="2381"/>
                        <a:pt x="338422" y="2186"/>
                        <a:pt x="371475" y="7144"/>
                      </a:cubicBezTo>
                      <a:cubicBezTo>
                        <a:pt x="386369" y="9378"/>
                        <a:pt x="414337" y="21431"/>
                        <a:pt x="414337" y="21431"/>
                      </a:cubicBezTo>
                      <a:lnTo>
                        <a:pt x="457200" y="50006"/>
                      </a:lnTo>
                      <a:lnTo>
                        <a:pt x="478631" y="64294"/>
                      </a:lnTo>
                      <a:cubicBezTo>
                        <a:pt x="485854" y="75129"/>
                        <a:pt x="500062" y="92369"/>
                        <a:pt x="500062" y="107156"/>
                      </a:cubicBezTo>
                      <a:cubicBezTo>
                        <a:pt x="500062" y="140579"/>
                        <a:pt x="498726" y="174255"/>
                        <a:pt x="492918" y="207169"/>
                      </a:cubicBezTo>
                      <a:cubicBezTo>
                        <a:pt x="491426" y="215624"/>
                        <a:pt x="485912" y="224050"/>
                        <a:pt x="478631" y="228600"/>
                      </a:cubicBezTo>
                      <a:cubicBezTo>
                        <a:pt x="478623" y="228605"/>
                        <a:pt x="425058" y="246458"/>
                        <a:pt x="414337" y="250031"/>
                      </a:cubicBezTo>
                      <a:lnTo>
                        <a:pt x="392906" y="257175"/>
                      </a:lnTo>
                      <a:cubicBezTo>
                        <a:pt x="385762" y="259556"/>
                        <a:pt x="378903" y="263081"/>
                        <a:pt x="371475" y="264319"/>
                      </a:cubicBezTo>
                      <a:cubicBezTo>
                        <a:pt x="269141" y="281374"/>
                        <a:pt x="314428" y="274509"/>
                        <a:pt x="235743" y="285750"/>
                      </a:cubicBezTo>
                      <a:cubicBezTo>
                        <a:pt x="178261" y="280960"/>
                        <a:pt x="164816" y="284475"/>
                        <a:pt x="121443" y="271463"/>
                      </a:cubicBezTo>
                      <a:cubicBezTo>
                        <a:pt x="121423" y="271457"/>
                        <a:pt x="67876" y="253606"/>
                        <a:pt x="57150" y="250031"/>
                      </a:cubicBezTo>
                      <a:lnTo>
                        <a:pt x="35718" y="242888"/>
                      </a:lnTo>
                      <a:cubicBezTo>
                        <a:pt x="28574" y="238125"/>
                        <a:pt x="18837" y="235881"/>
                        <a:pt x="14287" y="228600"/>
                      </a:cubicBezTo>
                      <a:cubicBezTo>
                        <a:pt x="6305" y="215829"/>
                        <a:pt x="0" y="185738"/>
                        <a:pt x="0" y="185738"/>
                      </a:cubicBezTo>
                      <a:cubicBezTo>
                        <a:pt x="2381" y="166688"/>
                        <a:pt x="2092" y="147110"/>
                        <a:pt x="7143" y="128588"/>
                      </a:cubicBezTo>
                      <a:cubicBezTo>
                        <a:pt x="11413" y="112931"/>
                        <a:pt x="29067" y="99000"/>
                        <a:pt x="42862" y="92869"/>
                      </a:cubicBezTo>
                      <a:lnTo>
                        <a:pt x="107156" y="64294"/>
                      </a:lnTo>
                      <a:close/>
                    </a:path>
                  </a:pathLst>
                </a:custGeom>
                <a:solidFill>
                  <a:schemeClr val="accent2"/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  <p:sp>
              <p:nvSpPr>
                <p:cNvPr id="24" name="Oval 23">
                  <a:extLst>
                    <a:ext uri="{FF2B5EF4-FFF2-40B4-BE49-F238E27FC236}">
                      <a16:creationId xmlns:a16="http://schemas.microsoft.com/office/drawing/2014/main" id="{FFA548D0-CCE3-687B-7DA2-2F70AA71B1F4}"/>
                    </a:ext>
                  </a:extLst>
                </p:cNvPr>
                <p:cNvSpPr/>
                <p:nvPr/>
              </p:nvSpPr>
              <p:spPr>
                <a:xfrm>
                  <a:off x="3691518" y="3769051"/>
                  <a:ext cx="121444" cy="50006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6CB92CD0-BC6D-3C20-A3E5-18EF79078255}"/>
                  </a:ext>
                </a:extLst>
              </p:cNvPr>
              <p:cNvGrpSpPr/>
              <p:nvPr/>
            </p:nvGrpSpPr>
            <p:grpSpPr>
              <a:xfrm>
                <a:off x="3759265" y="3729082"/>
                <a:ext cx="306461" cy="123091"/>
                <a:chOff x="3429000" y="3700462"/>
                <a:chExt cx="448256" cy="180043"/>
              </a:xfrm>
            </p:grpSpPr>
            <p:sp>
              <p:nvSpPr>
                <p:cNvPr id="21" name="Freeform 20">
                  <a:extLst>
                    <a:ext uri="{FF2B5EF4-FFF2-40B4-BE49-F238E27FC236}">
                      <a16:creationId xmlns:a16="http://schemas.microsoft.com/office/drawing/2014/main" id="{5A7ED921-3A17-56F4-4CBC-8CE1D3798AE2}"/>
                    </a:ext>
                  </a:extLst>
                </p:cNvPr>
                <p:cNvSpPr/>
                <p:nvPr/>
              </p:nvSpPr>
              <p:spPr>
                <a:xfrm>
                  <a:off x="3429000" y="3700462"/>
                  <a:ext cx="448256" cy="180043"/>
                </a:xfrm>
                <a:custGeom>
                  <a:avLst/>
                  <a:gdLst>
                    <a:gd name="connsiteX0" fmla="*/ 107156 w 500062"/>
                    <a:gd name="connsiteY0" fmla="*/ 64294 h 285750"/>
                    <a:gd name="connsiteX1" fmla="*/ 107156 w 500062"/>
                    <a:gd name="connsiteY1" fmla="*/ 64294 h 285750"/>
                    <a:gd name="connsiteX2" fmla="*/ 164306 w 500062"/>
                    <a:gd name="connsiteY2" fmla="*/ 42863 h 285750"/>
                    <a:gd name="connsiteX3" fmla="*/ 207168 w 500062"/>
                    <a:gd name="connsiteY3" fmla="*/ 28575 h 285750"/>
                    <a:gd name="connsiteX4" fmla="*/ 228600 w 500062"/>
                    <a:gd name="connsiteY4" fmla="*/ 14288 h 285750"/>
                    <a:gd name="connsiteX5" fmla="*/ 271462 w 500062"/>
                    <a:gd name="connsiteY5" fmla="*/ 0 h 285750"/>
                    <a:gd name="connsiteX6" fmla="*/ 371475 w 500062"/>
                    <a:gd name="connsiteY6" fmla="*/ 7144 h 285750"/>
                    <a:gd name="connsiteX7" fmla="*/ 414337 w 500062"/>
                    <a:gd name="connsiteY7" fmla="*/ 21431 h 285750"/>
                    <a:gd name="connsiteX8" fmla="*/ 457200 w 500062"/>
                    <a:gd name="connsiteY8" fmla="*/ 50006 h 285750"/>
                    <a:gd name="connsiteX9" fmla="*/ 478631 w 500062"/>
                    <a:gd name="connsiteY9" fmla="*/ 64294 h 285750"/>
                    <a:gd name="connsiteX10" fmla="*/ 500062 w 500062"/>
                    <a:gd name="connsiteY10" fmla="*/ 107156 h 285750"/>
                    <a:gd name="connsiteX11" fmla="*/ 492918 w 500062"/>
                    <a:gd name="connsiteY11" fmla="*/ 207169 h 285750"/>
                    <a:gd name="connsiteX12" fmla="*/ 478631 w 500062"/>
                    <a:gd name="connsiteY12" fmla="*/ 228600 h 285750"/>
                    <a:gd name="connsiteX13" fmla="*/ 414337 w 500062"/>
                    <a:gd name="connsiteY13" fmla="*/ 250031 h 285750"/>
                    <a:gd name="connsiteX14" fmla="*/ 392906 w 500062"/>
                    <a:gd name="connsiteY14" fmla="*/ 257175 h 285750"/>
                    <a:gd name="connsiteX15" fmla="*/ 371475 w 500062"/>
                    <a:gd name="connsiteY15" fmla="*/ 264319 h 285750"/>
                    <a:gd name="connsiteX16" fmla="*/ 235743 w 500062"/>
                    <a:gd name="connsiteY16" fmla="*/ 285750 h 285750"/>
                    <a:gd name="connsiteX17" fmla="*/ 121443 w 500062"/>
                    <a:gd name="connsiteY17" fmla="*/ 271463 h 285750"/>
                    <a:gd name="connsiteX18" fmla="*/ 57150 w 500062"/>
                    <a:gd name="connsiteY18" fmla="*/ 250031 h 285750"/>
                    <a:gd name="connsiteX19" fmla="*/ 35718 w 500062"/>
                    <a:gd name="connsiteY19" fmla="*/ 242888 h 285750"/>
                    <a:gd name="connsiteX20" fmla="*/ 14287 w 500062"/>
                    <a:gd name="connsiteY20" fmla="*/ 228600 h 285750"/>
                    <a:gd name="connsiteX21" fmla="*/ 0 w 500062"/>
                    <a:gd name="connsiteY21" fmla="*/ 185738 h 285750"/>
                    <a:gd name="connsiteX22" fmla="*/ 7143 w 500062"/>
                    <a:gd name="connsiteY22" fmla="*/ 128588 h 285750"/>
                    <a:gd name="connsiteX23" fmla="*/ 42862 w 500062"/>
                    <a:gd name="connsiteY23" fmla="*/ 92869 h 285750"/>
                    <a:gd name="connsiteX24" fmla="*/ 107156 w 500062"/>
                    <a:gd name="connsiteY24" fmla="*/ 64294 h 2857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</a:cxnLst>
                  <a:rect l="l" t="t" r="r" b="b"/>
                  <a:pathLst>
                    <a:path w="500062" h="285750">
                      <a:moveTo>
                        <a:pt x="107156" y="64294"/>
                      </a:moveTo>
                      <a:lnTo>
                        <a:pt x="107156" y="64294"/>
                      </a:lnTo>
                      <a:lnTo>
                        <a:pt x="164306" y="42863"/>
                      </a:lnTo>
                      <a:cubicBezTo>
                        <a:pt x="178489" y="37798"/>
                        <a:pt x="194637" y="36929"/>
                        <a:pt x="207168" y="28575"/>
                      </a:cubicBezTo>
                      <a:cubicBezTo>
                        <a:pt x="214312" y="23813"/>
                        <a:pt x="220754" y="17775"/>
                        <a:pt x="228600" y="14288"/>
                      </a:cubicBezTo>
                      <a:cubicBezTo>
                        <a:pt x="242362" y="8171"/>
                        <a:pt x="271462" y="0"/>
                        <a:pt x="271462" y="0"/>
                      </a:cubicBezTo>
                      <a:cubicBezTo>
                        <a:pt x="304800" y="2381"/>
                        <a:pt x="338422" y="2186"/>
                        <a:pt x="371475" y="7144"/>
                      </a:cubicBezTo>
                      <a:cubicBezTo>
                        <a:pt x="386369" y="9378"/>
                        <a:pt x="414337" y="21431"/>
                        <a:pt x="414337" y="21431"/>
                      </a:cubicBezTo>
                      <a:lnTo>
                        <a:pt x="457200" y="50006"/>
                      </a:lnTo>
                      <a:lnTo>
                        <a:pt x="478631" y="64294"/>
                      </a:lnTo>
                      <a:cubicBezTo>
                        <a:pt x="485854" y="75129"/>
                        <a:pt x="500062" y="92369"/>
                        <a:pt x="500062" y="107156"/>
                      </a:cubicBezTo>
                      <a:cubicBezTo>
                        <a:pt x="500062" y="140579"/>
                        <a:pt x="498726" y="174255"/>
                        <a:pt x="492918" y="207169"/>
                      </a:cubicBezTo>
                      <a:cubicBezTo>
                        <a:pt x="491426" y="215624"/>
                        <a:pt x="485912" y="224050"/>
                        <a:pt x="478631" y="228600"/>
                      </a:cubicBezTo>
                      <a:cubicBezTo>
                        <a:pt x="478623" y="228605"/>
                        <a:pt x="425058" y="246458"/>
                        <a:pt x="414337" y="250031"/>
                      </a:cubicBezTo>
                      <a:lnTo>
                        <a:pt x="392906" y="257175"/>
                      </a:lnTo>
                      <a:cubicBezTo>
                        <a:pt x="385762" y="259556"/>
                        <a:pt x="378903" y="263081"/>
                        <a:pt x="371475" y="264319"/>
                      </a:cubicBezTo>
                      <a:cubicBezTo>
                        <a:pt x="269141" y="281374"/>
                        <a:pt x="314428" y="274509"/>
                        <a:pt x="235743" y="285750"/>
                      </a:cubicBezTo>
                      <a:cubicBezTo>
                        <a:pt x="178261" y="280960"/>
                        <a:pt x="164816" y="284475"/>
                        <a:pt x="121443" y="271463"/>
                      </a:cubicBezTo>
                      <a:cubicBezTo>
                        <a:pt x="121423" y="271457"/>
                        <a:pt x="67876" y="253606"/>
                        <a:pt x="57150" y="250031"/>
                      </a:cubicBezTo>
                      <a:lnTo>
                        <a:pt x="35718" y="242888"/>
                      </a:lnTo>
                      <a:cubicBezTo>
                        <a:pt x="28574" y="238125"/>
                        <a:pt x="18837" y="235881"/>
                        <a:pt x="14287" y="228600"/>
                      </a:cubicBezTo>
                      <a:cubicBezTo>
                        <a:pt x="6305" y="215829"/>
                        <a:pt x="0" y="185738"/>
                        <a:pt x="0" y="185738"/>
                      </a:cubicBezTo>
                      <a:cubicBezTo>
                        <a:pt x="2381" y="166688"/>
                        <a:pt x="2092" y="147110"/>
                        <a:pt x="7143" y="128588"/>
                      </a:cubicBezTo>
                      <a:cubicBezTo>
                        <a:pt x="11413" y="112931"/>
                        <a:pt x="29067" y="99000"/>
                        <a:pt x="42862" y="92869"/>
                      </a:cubicBezTo>
                      <a:lnTo>
                        <a:pt x="107156" y="64294"/>
                      </a:lnTo>
                      <a:close/>
                    </a:path>
                  </a:pathLst>
                </a:custGeom>
                <a:solidFill>
                  <a:schemeClr val="accent2"/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  <p:sp>
              <p:nvSpPr>
                <p:cNvPr id="22" name="Oval 21">
                  <a:extLst>
                    <a:ext uri="{FF2B5EF4-FFF2-40B4-BE49-F238E27FC236}">
                      <a16:creationId xmlns:a16="http://schemas.microsoft.com/office/drawing/2014/main" id="{413B32F2-8FCB-287D-C2F0-D55F880C0855}"/>
                    </a:ext>
                  </a:extLst>
                </p:cNvPr>
                <p:cNvSpPr/>
                <p:nvPr/>
              </p:nvSpPr>
              <p:spPr>
                <a:xfrm>
                  <a:off x="3691518" y="3769051"/>
                  <a:ext cx="121444" cy="50006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</p:grp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E1EB651E-F58C-112D-FF78-702AB0860E5D}"/>
                </a:ext>
              </a:extLst>
            </p:cNvPr>
            <p:cNvGrpSpPr/>
            <p:nvPr/>
          </p:nvGrpSpPr>
          <p:grpSpPr>
            <a:xfrm>
              <a:off x="2056998" y="3358138"/>
              <a:ext cx="470314" cy="197102"/>
              <a:chOff x="3445660" y="3729082"/>
              <a:chExt cx="620066" cy="259861"/>
            </a:xfrm>
          </p:grpSpPr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99B77EAE-8A3A-5B74-EF81-3583D81B1B47}"/>
                  </a:ext>
                </a:extLst>
              </p:cNvPr>
              <p:cNvGrpSpPr/>
              <p:nvPr/>
            </p:nvGrpSpPr>
            <p:grpSpPr>
              <a:xfrm>
                <a:off x="3445660" y="3768831"/>
                <a:ext cx="306461" cy="123091"/>
                <a:chOff x="3429000" y="3700462"/>
                <a:chExt cx="448256" cy="180043"/>
              </a:xfrm>
            </p:grpSpPr>
            <p:sp>
              <p:nvSpPr>
                <p:cNvPr id="16" name="Freeform 15">
                  <a:extLst>
                    <a:ext uri="{FF2B5EF4-FFF2-40B4-BE49-F238E27FC236}">
                      <a16:creationId xmlns:a16="http://schemas.microsoft.com/office/drawing/2014/main" id="{83C57B81-BBD4-B329-34B8-C45F4706BF4B}"/>
                    </a:ext>
                  </a:extLst>
                </p:cNvPr>
                <p:cNvSpPr/>
                <p:nvPr/>
              </p:nvSpPr>
              <p:spPr>
                <a:xfrm>
                  <a:off x="3429000" y="3700462"/>
                  <a:ext cx="448256" cy="180043"/>
                </a:xfrm>
                <a:custGeom>
                  <a:avLst/>
                  <a:gdLst>
                    <a:gd name="connsiteX0" fmla="*/ 107156 w 500062"/>
                    <a:gd name="connsiteY0" fmla="*/ 64294 h 285750"/>
                    <a:gd name="connsiteX1" fmla="*/ 107156 w 500062"/>
                    <a:gd name="connsiteY1" fmla="*/ 64294 h 285750"/>
                    <a:gd name="connsiteX2" fmla="*/ 164306 w 500062"/>
                    <a:gd name="connsiteY2" fmla="*/ 42863 h 285750"/>
                    <a:gd name="connsiteX3" fmla="*/ 207168 w 500062"/>
                    <a:gd name="connsiteY3" fmla="*/ 28575 h 285750"/>
                    <a:gd name="connsiteX4" fmla="*/ 228600 w 500062"/>
                    <a:gd name="connsiteY4" fmla="*/ 14288 h 285750"/>
                    <a:gd name="connsiteX5" fmla="*/ 271462 w 500062"/>
                    <a:gd name="connsiteY5" fmla="*/ 0 h 285750"/>
                    <a:gd name="connsiteX6" fmla="*/ 371475 w 500062"/>
                    <a:gd name="connsiteY6" fmla="*/ 7144 h 285750"/>
                    <a:gd name="connsiteX7" fmla="*/ 414337 w 500062"/>
                    <a:gd name="connsiteY7" fmla="*/ 21431 h 285750"/>
                    <a:gd name="connsiteX8" fmla="*/ 457200 w 500062"/>
                    <a:gd name="connsiteY8" fmla="*/ 50006 h 285750"/>
                    <a:gd name="connsiteX9" fmla="*/ 478631 w 500062"/>
                    <a:gd name="connsiteY9" fmla="*/ 64294 h 285750"/>
                    <a:gd name="connsiteX10" fmla="*/ 500062 w 500062"/>
                    <a:gd name="connsiteY10" fmla="*/ 107156 h 285750"/>
                    <a:gd name="connsiteX11" fmla="*/ 492918 w 500062"/>
                    <a:gd name="connsiteY11" fmla="*/ 207169 h 285750"/>
                    <a:gd name="connsiteX12" fmla="*/ 478631 w 500062"/>
                    <a:gd name="connsiteY12" fmla="*/ 228600 h 285750"/>
                    <a:gd name="connsiteX13" fmla="*/ 414337 w 500062"/>
                    <a:gd name="connsiteY13" fmla="*/ 250031 h 285750"/>
                    <a:gd name="connsiteX14" fmla="*/ 392906 w 500062"/>
                    <a:gd name="connsiteY14" fmla="*/ 257175 h 285750"/>
                    <a:gd name="connsiteX15" fmla="*/ 371475 w 500062"/>
                    <a:gd name="connsiteY15" fmla="*/ 264319 h 285750"/>
                    <a:gd name="connsiteX16" fmla="*/ 235743 w 500062"/>
                    <a:gd name="connsiteY16" fmla="*/ 285750 h 285750"/>
                    <a:gd name="connsiteX17" fmla="*/ 121443 w 500062"/>
                    <a:gd name="connsiteY17" fmla="*/ 271463 h 285750"/>
                    <a:gd name="connsiteX18" fmla="*/ 57150 w 500062"/>
                    <a:gd name="connsiteY18" fmla="*/ 250031 h 285750"/>
                    <a:gd name="connsiteX19" fmla="*/ 35718 w 500062"/>
                    <a:gd name="connsiteY19" fmla="*/ 242888 h 285750"/>
                    <a:gd name="connsiteX20" fmla="*/ 14287 w 500062"/>
                    <a:gd name="connsiteY20" fmla="*/ 228600 h 285750"/>
                    <a:gd name="connsiteX21" fmla="*/ 0 w 500062"/>
                    <a:gd name="connsiteY21" fmla="*/ 185738 h 285750"/>
                    <a:gd name="connsiteX22" fmla="*/ 7143 w 500062"/>
                    <a:gd name="connsiteY22" fmla="*/ 128588 h 285750"/>
                    <a:gd name="connsiteX23" fmla="*/ 42862 w 500062"/>
                    <a:gd name="connsiteY23" fmla="*/ 92869 h 285750"/>
                    <a:gd name="connsiteX24" fmla="*/ 107156 w 500062"/>
                    <a:gd name="connsiteY24" fmla="*/ 64294 h 2857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</a:cxnLst>
                  <a:rect l="l" t="t" r="r" b="b"/>
                  <a:pathLst>
                    <a:path w="500062" h="285750">
                      <a:moveTo>
                        <a:pt x="107156" y="64294"/>
                      </a:moveTo>
                      <a:lnTo>
                        <a:pt x="107156" y="64294"/>
                      </a:lnTo>
                      <a:lnTo>
                        <a:pt x="164306" y="42863"/>
                      </a:lnTo>
                      <a:cubicBezTo>
                        <a:pt x="178489" y="37798"/>
                        <a:pt x="194637" y="36929"/>
                        <a:pt x="207168" y="28575"/>
                      </a:cubicBezTo>
                      <a:cubicBezTo>
                        <a:pt x="214312" y="23813"/>
                        <a:pt x="220754" y="17775"/>
                        <a:pt x="228600" y="14288"/>
                      </a:cubicBezTo>
                      <a:cubicBezTo>
                        <a:pt x="242362" y="8171"/>
                        <a:pt x="271462" y="0"/>
                        <a:pt x="271462" y="0"/>
                      </a:cubicBezTo>
                      <a:cubicBezTo>
                        <a:pt x="304800" y="2381"/>
                        <a:pt x="338422" y="2186"/>
                        <a:pt x="371475" y="7144"/>
                      </a:cubicBezTo>
                      <a:cubicBezTo>
                        <a:pt x="386369" y="9378"/>
                        <a:pt x="414337" y="21431"/>
                        <a:pt x="414337" y="21431"/>
                      </a:cubicBezTo>
                      <a:lnTo>
                        <a:pt x="457200" y="50006"/>
                      </a:lnTo>
                      <a:lnTo>
                        <a:pt x="478631" y="64294"/>
                      </a:lnTo>
                      <a:cubicBezTo>
                        <a:pt x="485854" y="75129"/>
                        <a:pt x="500062" y="92369"/>
                        <a:pt x="500062" y="107156"/>
                      </a:cubicBezTo>
                      <a:cubicBezTo>
                        <a:pt x="500062" y="140579"/>
                        <a:pt x="498726" y="174255"/>
                        <a:pt x="492918" y="207169"/>
                      </a:cubicBezTo>
                      <a:cubicBezTo>
                        <a:pt x="491426" y="215624"/>
                        <a:pt x="485912" y="224050"/>
                        <a:pt x="478631" y="228600"/>
                      </a:cubicBezTo>
                      <a:cubicBezTo>
                        <a:pt x="478623" y="228605"/>
                        <a:pt x="425058" y="246458"/>
                        <a:pt x="414337" y="250031"/>
                      </a:cubicBezTo>
                      <a:lnTo>
                        <a:pt x="392906" y="257175"/>
                      </a:lnTo>
                      <a:cubicBezTo>
                        <a:pt x="385762" y="259556"/>
                        <a:pt x="378903" y="263081"/>
                        <a:pt x="371475" y="264319"/>
                      </a:cubicBezTo>
                      <a:cubicBezTo>
                        <a:pt x="269141" y="281374"/>
                        <a:pt x="314428" y="274509"/>
                        <a:pt x="235743" y="285750"/>
                      </a:cubicBezTo>
                      <a:cubicBezTo>
                        <a:pt x="178261" y="280960"/>
                        <a:pt x="164816" y="284475"/>
                        <a:pt x="121443" y="271463"/>
                      </a:cubicBezTo>
                      <a:cubicBezTo>
                        <a:pt x="121423" y="271457"/>
                        <a:pt x="67876" y="253606"/>
                        <a:pt x="57150" y="250031"/>
                      </a:cubicBezTo>
                      <a:lnTo>
                        <a:pt x="35718" y="242888"/>
                      </a:lnTo>
                      <a:cubicBezTo>
                        <a:pt x="28574" y="238125"/>
                        <a:pt x="18837" y="235881"/>
                        <a:pt x="14287" y="228600"/>
                      </a:cubicBezTo>
                      <a:cubicBezTo>
                        <a:pt x="6305" y="215829"/>
                        <a:pt x="0" y="185738"/>
                        <a:pt x="0" y="185738"/>
                      </a:cubicBezTo>
                      <a:cubicBezTo>
                        <a:pt x="2381" y="166688"/>
                        <a:pt x="2092" y="147110"/>
                        <a:pt x="7143" y="128588"/>
                      </a:cubicBezTo>
                      <a:cubicBezTo>
                        <a:pt x="11413" y="112931"/>
                        <a:pt x="29067" y="99000"/>
                        <a:pt x="42862" y="92869"/>
                      </a:cubicBezTo>
                      <a:lnTo>
                        <a:pt x="107156" y="64294"/>
                      </a:lnTo>
                      <a:close/>
                    </a:path>
                  </a:pathLst>
                </a:custGeom>
                <a:solidFill>
                  <a:schemeClr val="accent2"/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  <p:sp>
              <p:nvSpPr>
                <p:cNvPr id="17" name="Oval 16">
                  <a:extLst>
                    <a:ext uri="{FF2B5EF4-FFF2-40B4-BE49-F238E27FC236}">
                      <a16:creationId xmlns:a16="http://schemas.microsoft.com/office/drawing/2014/main" id="{BF37AD43-F649-44F9-4F98-B0B0A45DBD97}"/>
                    </a:ext>
                  </a:extLst>
                </p:cNvPr>
                <p:cNvSpPr/>
                <p:nvPr/>
              </p:nvSpPr>
              <p:spPr>
                <a:xfrm>
                  <a:off x="3691518" y="3769051"/>
                  <a:ext cx="121444" cy="50006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548047EA-1BF9-2289-442E-AC053BA2C222}"/>
                  </a:ext>
                </a:extLst>
              </p:cNvPr>
              <p:cNvGrpSpPr/>
              <p:nvPr/>
            </p:nvGrpSpPr>
            <p:grpSpPr>
              <a:xfrm>
                <a:off x="3649991" y="3865852"/>
                <a:ext cx="306461" cy="123091"/>
                <a:chOff x="3429000" y="3700462"/>
                <a:chExt cx="448256" cy="180043"/>
              </a:xfrm>
            </p:grpSpPr>
            <p:sp>
              <p:nvSpPr>
                <p:cNvPr id="14" name="Freeform 13">
                  <a:extLst>
                    <a:ext uri="{FF2B5EF4-FFF2-40B4-BE49-F238E27FC236}">
                      <a16:creationId xmlns:a16="http://schemas.microsoft.com/office/drawing/2014/main" id="{E75E5AE2-5301-D4C2-4B13-64D81E2D2F8D}"/>
                    </a:ext>
                  </a:extLst>
                </p:cNvPr>
                <p:cNvSpPr/>
                <p:nvPr/>
              </p:nvSpPr>
              <p:spPr>
                <a:xfrm>
                  <a:off x="3429000" y="3700462"/>
                  <a:ext cx="448256" cy="180043"/>
                </a:xfrm>
                <a:custGeom>
                  <a:avLst/>
                  <a:gdLst>
                    <a:gd name="connsiteX0" fmla="*/ 107156 w 500062"/>
                    <a:gd name="connsiteY0" fmla="*/ 64294 h 285750"/>
                    <a:gd name="connsiteX1" fmla="*/ 107156 w 500062"/>
                    <a:gd name="connsiteY1" fmla="*/ 64294 h 285750"/>
                    <a:gd name="connsiteX2" fmla="*/ 164306 w 500062"/>
                    <a:gd name="connsiteY2" fmla="*/ 42863 h 285750"/>
                    <a:gd name="connsiteX3" fmla="*/ 207168 w 500062"/>
                    <a:gd name="connsiteY3" fmla="*/ 28575 h 285750"/>
                    <a:gd name="connsiteX4" fmla="*/ 228600 w 500062"/>
                    <a:gd name="connsiteY4" fmla="*/ 14288 h 285750"/>
                    <a:gd name="connsiteX5" fmla="*/ 271462 w 500062"/>
                    <a:gd name="connsiteY5" fmla="*/ 0 h 285750"/>
                    <a:gd name="connsiteX6" fmla="*/ 371475 w 500062"/>
                    <a:gd name="connsiteY6" fmla="*/ 7144 h 285750"/>
                    <a:gd name="connsiteX7" fmla="*/ 414337 w 500062"/>
                    <a:gd name="connsiteY7" fmla="*/ 21431 h 285750"/>
                    <a:gd name="connsiteX8" fmla="*/ 457200 w 500062"/>
                    <a:gd name="connsiteY8" fmla="*/ 50006 h 285750"/>
                    <a:gd name="connsiteX9" fmla="*/ 478631 w 500062"/>
                    <a:gd name="connsiteY9" fmla="*/ 64294 h 285750"/>
                    <a:gd name="connsiteX10" fmla="*/ 500062 w 500062"/>
                    <a:gd name="connsiteY10" fmla="*/ 107156 h 285750"/>
                    <a:gd name="connsiteX11" fmla="*/ 492918 w 500062"/>
                    <a:gd name="connsiteY11" fmla="*/ 207169 h 285750"/>
                    <a:gd name="connsiteX12" fmla="*/ 478631 w 500062"/>
                    <a:gd name="connsiteY12" fmla="*/ 228600 h 285750"/>
                    <a:gd name="connsiteX13" fmla="*/ 414337 w 500062"/>
                    <a:gd name="connsiteY13" fmla="*/ 250031 h 285750"/>
                    <a:gd name="connsiteX14" fmla="*/ 392906 w 500062"/>
                    <a:gd name="connsiteY14" fmla="*/ 257175 h 285750"/>
                    <a:gd name="connsiteX15" fmla="*/ 371475 w 500062"/>
                    <a:gd name="connsiteY15" fmla="*/ 264319 h 285750"/>
                    <a:gd name="connsiteX16" fmla="*/ 235743 w 500062"/>
                    <a:gd name="connsiteY16" fmla="*/ 285750 h 285750"/>
                    <a:gd name="connsiteX17" fmla="*/ 121443 w 500062"/>
                    <a:gd name="connsiteY17" fmla="*/ 271463 h 285750"/>
                    <a:gd name="connsiteX18" fmla="*/ 57150 w 500062"/>
                    <a:gd name="connsiteY18" fmla="*/ 250031 h 285750"/>
                    <a:gd name="connsiteX19" fmla="*/ 35718 w 500062"/>
                    <a:gd name="connsiteY19" fmla="*/ 242888 h 285750"/>
                    <a:gd name="connsiteX20" fmla="*/ 14287 w 500062"/>
                    <a:gd name="connsiteY20" fmla="*/ 228600 h 285750"/>
                    <a:gd name="connsiteX21" fmla="*/ 0 w 500062"/>
                    <a:gd name="connsiteY21" fmla="*/ 185738 h 285750"/>
                    <a:gd name="connsiteX22" fmla="*/ 7143 w 500062"/>
                    <a:gd name="connsiteY22" fmla="*/ 128588 h 285750"/>
                    <a:gd name="connsiteX23" fmla="*/ 42862 w 500062"/>
                    <a:gd name="connsiteY23" fmla="*/ 92869 h 285750"/>
                    <a:gd name="connsiteX24" fmla="*/ 107156 w 500062"/>
                    <a:gd name="connsiteY24" fmla="*/ 64294 h 2857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</a:cxnLst>
                  <a:rect l="l" t="t" r="r" b="b"/>
                  <a:pathLst>
                    <a:path w="500062" h="285750">
                      <a:moveTo>
                        <a:pt x="107156" y="64294"/>
                      </a:moveTo>
                      <a:lnTo>
                        <a:pt x="107156" y="64294"/>
                      </a:lnTo>
                      <a:lnTo>
                        <a:pt x="164306" y="42863"/>
                      </a:lnTo>
                      <a:cubicBezTo>
                        <a:pt x="178489" y="37798"/>
                        <a:pt x="194637" y="36929"/>
                        <a:pt x="207168" y="28575"/>
                      </a:cubicBezTo>
                      <a:cubicBezTo>
                        <a:pt x="214312" y="23813"/>
                        <a:pt x="220754" y="17775"/>
                        <a:pt x="228600" y="14288"/>
                      </a:cubicBezTo>
                      <a:cubicBezTo>
                        <a:pt x="242362" y="8171"/>
                        <a:pt x="271462" y="0"/>
                        <a:pt x="271462" y="0"/>
                      </a:cubicBezTo>
                      <a:cubicBezTo>
                        <a:pt x="304800" y="2381"/>
                        <a:pt x="338422" y="2186"/>
                        <a:pt x="371475" y="7144"/>
                      </a:cubicBezTo>
                      <a:cubicBezTo>
                        <a:pt x="386369" y="9378"/>
                        <a:pt x="414337" y="21431"/>
                        <a:pt x="414337" y="21431"/>
                      </a:cubicBezTo>
                      <a:lnTo>
                        <a:pt x="457200" y="50006"/>
                      </a:lnTo>
                      <a:lnTo>
                        <a:pt x="478631" y="64294"/>
                      </a:lnTo>
                      <a:cubicBezTo>
                        <a:pt x="485854" y="75129"/>
                        <a:pt x="500062" y="92369"/>
                        <a:pt x="500062" y="107156"/>
                      </a:cubicBezTo>
                      <a:cubicBezTo>
                        <a:pt x="500062" y="140579"/>
                        <a:pt x="498726" y="174255"/>
                        <a:pt x="492918" y="207169"/>
                      </a:cubicBezTo>
                      <a:cubicBezTo>
                        <a:pt x="491426" y="215624"/>
                        <a:pt x="485912" y="224050"/>
                        <a:pt x="478631" y="228600"/>
                      </a:cubicBezTo>
                      <a:cubicBezTo>
                        <a:pt x="478623" y="228605"/>
                        <a:pt x="425058" y="246458"/>
                        <a:pt x="414337" y="250031"/>
                      </a:cubicBezTo>
                      <a:lnTo>
                        <a:pt x="392906" y="257175"/>
                      </a:lnTo>
                      <a:cubicBezTo>
                        <a:pt x="385762" y="259556"/>
                        <a:pt x="378903" y="263081"/>
                        <a:pt x="371475" y="264319"/>
                      </a:cubicBezTo>
                      <a:cubicBezTo>
                        <a:pt x="269141" y="281374"/>
                        <a:pt x="314428" y="274509"/>
                        <a:pt x="235743" y="285750"/>
                      </a:cubicBezTo>
                      <a:cubicBezTo>
                        <a:pt x="178261" y="280960"/>
                        <a:pt x="164816" y="284475"/>
                        <a:pt x="121443" y="271463"/>
                      </a:cubicBezTo>
                      <a:cubicBezTo>
                        <a:pt x="121423" y="271457"/>
                        <a:pt x="67876" y="253606"/>
                        <a:pt x="57150" y="250031"/>
                      </a:cubicBezTo>
                      <a:lnTo>
                        <a:pt x="35718" y="242888"/>
                      </a:lnTo>
                      <a:cubicBezTo>
                        <a:pt x="28574" y="238125"/>
                        <a:pt x="18837" y="235881"/>
                        <a:pt x="14287" y="228600"/>
                      </a:cubicBezTo>
                      <a:cubicBezTo>
                        <a:pt x="6305" y="215829"/>
                        <a:pt x="0" y="185738"/>
                        <a:pt x="0" y="185738"/>
                      </a:cubicBezTo>
                      <a:cubicBezTo>
                        <a:pt x="2381" y="166688"/>
                        <a:pt x="2092" y="147110"/>
                        <a:pt x="7143" y="128588"/>
                      </a:cubicBezTo>
                      <a:cubicBezTo>
                        <a:pt x="11413" y="112931"/>
                        <a:pt x="29067" y="99000"/>
                        <a:pt x="42862" y="92869"/>
                      </a:cubicBezTo>
                      <a:lnTo>
                        <a:pt x="107156" y="64294"/>
                      </a:lnTo>
                      <a:close/>
                    </a:path>
                  </a:pathLst>
                </a:custGeom>
                <a:solidFill>
                  <a:schemeClr val="accent2"/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  <p:sp>
              <p:nvSpPr>
                <p:cNvPr id="15" name="Oval 14">
                  <a:extLst>
                    <a:ext uri="{FF2B5EF4-FFF2-40B4-BE49-F238E27FC236}">
                      <a16:creationId xmlns:a16="http://schemas.microsoft.com/office/drawing/2014/main" id="{CED7450B-353E-1C32-E696-D4B97FB7F44D}"/>
                    </a:ext>
                  </a:extLst>
                </p:cNvPr>
                <p:cNvSpPr/>
                <p:nvPr/>
              </p:nvSpPr>
              <p:spPr>
                <a:xfrm>
                  <a:off x="3691518" y="3769051"/>
                  <a:ext cx="121444" cy="50006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</p:grp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DB742E02-153A-ECDE-6E2B-8B62C7EAA9FA}"/>
                  </a:ext>
                </a:extLst>
              </p:cNvPr>
              <p:cNvGrpSpPr/>
              <p:nvPr/>
            </p:nvGrpSpPr>
            <p:grpSpPr>
              <a:xfrm>
                <a:off x="3759265" y="3729082"/>
                <a:ext cx="306461" cy="123091"/>
                <a:chOff x="3429000" y="3700462"/>
                <a:chExt cx="448256" cy="180043"/>
              </a:xfrm>
            </p:grpSpPr>
            <p:sp>
              <p:nvSpPr>
                <p:cNvPr id="12" name="Freeform 11">
                  <a:extLst>
                    <a:ext uri="{FF2B5EF4-FFF2-40B4-BE49-F238E27FC236}">
                      <a16:creationId xmlns:a16="http://schemas.microsoft.com/office/drawing/2014/main" id="{AE4825B1-8855-769F-679E-A2E1CF6A588F}"/>
                    </a:ext>
                  </a:extLst>
                </p:cNvPr>
                <p:cNvSpPr/>
                <p:nvPr/>
              </p:nvSpPr>
              <p:spPr>
                <a:xfrm>
                  <a:off x="3429000" y="3700462"/>
                  <a:ext cx="448256" cy="180043"/>
                </a:xfrm>
                <a:custGeom>
                  <a:avLst/>
                  <a:gdLst>
                    <a:gd name="connsiteX0" fmla="*/ 107156 w 500062"/>
                    <a:gd name="connsiteY0" fmla="*/ 64294 h 285750"/>
                    <a:gd name="connsiteX1" fmla="*/ 107156 w 500062"/>
                    <a:gd name="connsiteY1" fmla="*/ 64294 h 285750"/>
                    <a:gd name="connsiteX2" fmla="*/ 164306 w 500062"/>
                    <a:gd name="connsiteY2" fmla="*/ 42863 h 285750"/>
                    <a:gd name="connsiteX3" fmla="*/ 207168 w 500062"/>
                    <a:gd name="connsiteY3" fmla="*/ 28575 h 285750"/>
                    <a:gd name="connsiteX4" fmla="*/ 228600 w 500062"/>
                    <a:gd name="connsiteY4" fmla="*/ 14288 h 285750"/>
                    <a:gd name="connsiteX5" fmla="*/ 271462 w 500062"/>
                    <a:gd name="connsiteY5" fmla="*/ 0 h 285750"/>
                    <a:gd name="connsiteX6" fmla="*/ 371475 w 500062"/>
                    <a:gd name="connsiteY6" fmla="*/ 7144 h 285750"/>
                    <a:gd name="connsiteX7" fmla="*/ 414337 w 500062"/>
                    <a:gd name="connsiteY7" fmla="*/ 21431 h 285750"/>
                    <a:gd name="connsiteX8" fmla="*/ 457200 w 500062"/>
                    <a:gd name="connsiteY8" fmla="*/ 50006 h 285750"/>
                    <a:gd name="connsiteX9" fmla="*/ 478631 w 500062"/>
                    <a:gd name="connsiteY9" fmla="*/ 64294 h 285750"/>
                    <a:gd name="connsiteX10" fmla="*/ 500062 w 500062"/>
                    <a:gd name="connsiteY10" fmla="*/ 107156 h 285750"/>
                    <a:gd name="connsiteX11" fmla="*/ 492918 w 500062"/>
                    <a:gd name="connsiteY11" fmla="*/ 207169 h 285750"/>
                    <a:gd name="connsiteX12" fmla="*/ 478631 w 500062"/>
                    <a:gd name="connsiteY12" fmla="*/ 228600 h 285750"/>
                    <a:gd name="connsiteX13" fmla="*/ 414337 w 500062"/>
                    <a:gd name="connsiteY13" fmla="*/ 250031 h 285750"/>
                    <a:gd name="connsiteX14" fmla="*/ 392906 w 500062"/>
                    <a:gd name="connsiteY14" fmla="*/ 257175 h 285750"/>
                    <a:gd name="connsiteX15" fmla="*/ 371475 w 500062"/>
                    <a:gd name="connsiteY15" fmla="*/ 264319 h 285750"/>
                    <a:gd name="connsiteX16" fmla="*/ 235743 w 500062"/>
                    <a:gd name="connsiteY16" fmla="*/ 285750 h 285750"/>
                    <a:gd name="connsiteX17" fmla="*/ 121443 w 500062"/>
                    <a:gd name="connsiteY17" fmla="*/ 271463 h 285750"/>
                    <a:gd name="connsiteX18" fmla="*/ 57150 w 500062"/>
                    <a:gd name="connsiteY18" fmla="*/ 250031 h 285750"/>
                    <a:gd name="connsiteX19" fmla="*/ 35718 w 500062"/>
                    <a:gd name="connsiteY19" fmla="*/ 242888 h 285750"/>
                    <a:gd name="connsiteX20" fmla="*/ 14287 w 500062"/>
                    <a:gd name="connsiteY20" fmla="*/ 228600 h 285750"/>
                    <a:gd name="connsiteX21" fmla="*/ 0 w 500062"/>
                    <a:gd name="connsiteY21" fmla="*/ 185738 h 285750"/>
                    <a:gd name="connsiteX22" fmla="*/ 7143 w 500062"/>
                    <a:gd name="connsiteY22" fmla="*/ 128588 h 285750"/>
                    <a:gd name="connsiteX23" fmla="*/ 42862 w 500062"/>
                    <a:gd name="connsiteY23" fmla="*/ 92869 h 285750"/>
                    <a:gd name="connsiteX24" fmla="*/ 107156 w 500062"/>
                    <a:gd name="connsiteY24" fmla="*/ 64294 h 2857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</a:cxnLst>
                  <a:rect l="l" t="t" r="r" b="b"/>
                  <a:pathLst>
                    <a:path w="500062" h="285750">
                      <a:moveTo>
                        <a:pt x="107156" y="64294"/>
                      </a:moveTo>
                      <a:lnTo>
                        <a:pt x="107156" y="64294"/>
                      </a:lnTo>
                      <a:lnTo>
                        <a:pt x="164306" y="42863"/>
                      </a:lnTo>
                      <a:cubicBezTo>
                        <a:pt x="178489" y="37798"/>
                        <a:pt x="194637" y="36929"/>
                        <a:pt x="207168" y="28575"/>
                      </a:cubicBezTo>
                      <a:cubicBezTo>
                        <a:pt x="214312" y="23813"/>
                        <a:pt x="220754" y="17775"/>
                        <a:pt x="228600" y="14288"/>
                      </a:cubicBezTo>
                      <a:cubicBezTo>
                        <a:pt x="242362" y="8171"/>
                        <a:pt x="271462" y="0"/>
                        <a:pt x="271462" y="0"/>
                      </a:cubicBezTo>
                      <a:cubicBezTo>
                        <a:pt x="304800" y="2381"/>
                        <a:pt x="338422" y="2186"/>
                        <a:pt x="371475" y="7144"/>
                      </a:cubicBezTo>
                      <a:cubicBezTo>
                        <a:pt x="386369" y="9378"/>
                        <a:pt x="414337" y="21431"/>
                        <a:pt x="414337" y="21431"/>
                      </a:cubicBezTo>
                      <a:lnTo>
                        <a:pt x="457200" y="50006"/>
                      </a:lnTo>
                      <a:lnTo>
                        <a:pt x="478631" y="64294"/>
                      </a:lnTo>
                      <a:cubicBezTo>
                        <a:pt x="485854" y="75129"/>
                        <a:pt x="500062" y="92369"/>
                        <a:pt x="500062" y="107156"/>
                      </a:cubicBezTo>
                      <a:cubicBezTo>
                        <a:pt x="500062" y="140579"/>
                        <a:pt x="498726" y="174255"/>
                        <a:pt x="492918" y="207169"/>
                      </a:cubicBezTo>
                      <a:cubicBezTo>
                        <a:pt x="491426" y="215624"/>
                        <a:pt x="485912" y="224050"/>
                        <a:pt x="478631" y="228600"/>
                      </a:cubicBezTo>
                      <a:cubicBezTo>
                        <a:pt x="478623" y="228605"/>
                        <a:pt x="425058" y="246458"/>
                        <a:pt x="414337" y="250031"/>
                      </a:cubicBezTo>
                      <a:lnTo>
                        <a:pt x="392906" y="257175"/>
                      </a:lnTo>
                      <a:cubicBezTo>
                        <a:pt x="385762" y="259556"/>
                        <a:pt x="378903" y="263081"/>
                        <a:pt x="371475" y="264319"/>
                      </a:cubicBezTo>
                      <a:cubicBezTo>
                        <a:pt x="269141" y="281374"/>
                        <a:pt x="314428" y="274509"/>
                        <a:pt x="235743" y="285750"/>
                      </a:cubicBezTo>
                      <a:cubicBezTo>
                        <a:pt x="178261" y="280960"/>
                        <a:pt x="164816" y="284475"/>
                        <a:pt x="121443" y="271463"/>
                      </a:cubicBezTo>
                      <a:cubicBezTo>
                        <a:pt x="121423" y="271457"/>
                        <a:pt x="67876" y="253606"/>
                        <a:pt x="57150" y="250031"/>
                      </a:cubicBezTo>
                      <a:lnTo>
                        <a:pt x="35718" y="242888"/>
                      </a:lnTo>
                      <a:cubicBezTo>
                        <a:pt x="28574" y="238125"/>
                        <a:pt x="18837" y="235881"/>
                        <a:pt x="14287" y="228600"/>
                      </a:cubicBezTo>
                      <a:cubicBezTo>
                        <a:pt x="6305" y="215829"/>
                        <a:pt x="0" y="185738"/>
                        <a:pt x="0" y="185738"/>
                      </a:cubicBezTo>
                      <a:cubicBezTo>
                        <a:pt x="2381" y="166688"/>
                        <a:pt x="2092" y="147110"/>
                        <a:pt x="7143" y="128588"/>
                      </a:cubicBezTo>
                      <a:cubicBezTo>
                        <a:pt x="11413" y="112931"/>
                        <a:pt x="29067" y="99000"/>
                        <a:pt x="42862" y="92869"/>
                      </a:cubicBezTo>
                      <a:lnTo>
                        <a:pt x="107156" y="64294"/>
                      </a:lnTo>
                      <a:close/>
                    </a:path>
                  </a:pathLst>
                </a:custGeom>
                <a:solidFill>
                  <a:schemeClr val="accent2"/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  <p:sp>
              <p:nvSpPr>
                <p:cNvPr id="13" name="Oval 12">
                  <a:extLst>
                    <a:ext uri="{FF2B5EF4-FFF2-40B4-BE49-F238E27FC236}">
                      <a16:creationId xmlns:a16="http://schemas.microsoft.com/office/drawing/2014/main" id="{B9FC0D0D-0D56-DCFB-3520-0EDF5E321612}"/>
                    </a:ext>
                  </a:extLst>
                </p:cNvPr>
                <p:cNvSpPr/>
                <p:nvPr/>
              </p:nvSpPr>
              <p:spPr>
                <a:xfrm>
                  <a:off x="3691518" y="3769051"/>
                  <a:ext cx="121444" cy="50006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Helvetica" pitchFamily="2" charset="0"/>
                  </a:endParaRPr>
                </a:p>
              </p:txBody>
            </p:sp>
          </p:grpSp>
        </p:grp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675DBC34-EBBC-C8EC-F737-245B72BC25C5}"/>
              </a:ext>
            </a:extLst>
          </p:cNvPr>
          <p:cNvGrpSpPr/>
          <p:nvPr/>
        </p:nvGrpSpPr>
        <p:grpSpPr>
          <a:xfrm>
            <a:off x="2218501" y="733067"/>
            <a:ext cx="1281511" cy="564043"/>
            <a:chOff x="594164" y="1415416"/>
            <a:chExt cx="1281511" cy="564043"/>
          </a:xfrm>
        </p:grpSpPr>
        <p:pic>
          <p:nvPicPr>
            <p:cNvPr id="37" name="Picture 4" descr="Cell clipart cell culture, Picture #165188 cell clipart cell culture">
              <a:extLst>
                <a:ext uri="{FF2B5EF4-FFF2-40B4-BE49-F238E27FC236}">
                  <a16:creationId xmlns:a16="http://schemas.microsoft.com/office/drawing/2014/main" id="{1A6E6BE9-15CC-FB34-8CEA-11D48F84658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94164" y="1415416"/>
              <a:ext cx="1281511" cy="56404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734D241E-0E4D-6BE0-312A-97186A796E8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39139" y="1720054"/>
              <a:ext cx="498364" cy="204626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E437A919-ABF2-E4A2-058F-DB1234BDF26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95961" y="1752942"/>
              <a:ext cx="498364" cy="204626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89FFE8FC-DD53-46DF-3D1A-4E690743F63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334139" y="1720054"/>
              <a:ext cx="498364" cy="204626"/>
            </a:xfrm>
            <a:prstGeom prst="rect">
              <a:avLst/>
            </a:prstGeom>
          </p:spPr>
        </p:pic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A0DB9FF6-88B8-43BC-63B2-7B7BC4EFE857}"/>
              </a:ext>
            </a:extLst>
          </p:cNvPr>
          <p:cNvSpPr txBox="1"/>
          <p:nvPr/>
        </p:nvSpPr>
        <p:spPr>
          <a:xfrm>
            <a:off x="2110831" y="1332263"/>
            <a:ext cx="15215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CDUPRT-</a:t>
            </a:r>
            <a:r>
              <a:rPr lang="en-US" sz="1100" dirty="0" err="1">
                <a:latin typeface="Helvetica" pitchFamily="2" charset="0"/>
              </a:rPr>
              <a:t>IFNb_MSC</a:t>
            </a:r>
            <a:endParaRPr lang="en-US" sz="1100" dirty="0">
              <a:latin typeface="Helvetica" pitchFamily="2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B183CA7-4529-1FB0-9E55-3A054A1DB3C5}"/>
              </a:ext>
            </a:extLst>
          </p:cNvPr>
          <p:cNvSpPr txBox="1"/>
          <p:nvPr/>
        </p:nvSpPr>
        <p:spPr>
          <a:xfrm>
            <a:off x="2183514" y="3045581"/>
            <a:ext cx="12987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A549 cancer cells</a:t>
            </a:r>
          </a:p>
        </p:txBody>
      </p:sp>
      <p:sp>
        <p:nvSpPr>
          <p:cNvPr id="43" name="Down Arrow 42">
            <a:extLst>
              <a:ext uri="{FF2B5EF4-FFF2-40B4-BE49-F238E27FC236}">
                <a16:creationId xmlns:a16="http://schemas.microsoft.com/office/drawing/2014/main" id="{C532E0A3-6352-C2DD-0AAE-240DBCA71FF6}"/>
              </a:ext>
            </a:extLst>
          </p:cNvPr>
          <p:cNvSpPr/>
          <p:nvPr/>
        </p:nvSpPr>
        <p:spPr>
          <a:xfrm>
            <a:off x="2773870" y="1658750"/>
            <a:ext cx="184606" cy="682374"/>
          </a:xfrm>
          <a:prstGeom prst="downArrow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Helvetica" pitchFamily="2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D675DC4-1EB6-6C24-D0C9-18F2BDC4CD98}"/>
              </a:ext>
            </a:extLst>
          </p:cNvPr>
          <p:cNvSpPr txBox="1"/>
          <p:nvPr/>
        </p:nvSpPr>
        <p:spPr>
          <a:xfrm>
            <a:off x="2911763" y="1763819"/>
            <a:ext cx="10628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Helvetica" pitchFamily="2" charset="0"/>
              </a:rPr>
              <a:t>Conditioned medium</a:t>
            </a:r>
          </a:p>
        </p:txBody>
      </p:sp>
      <p:sp>
        <p:nvSpPr>
          <p:cNvPr id="45" name="Down Arrow 44">
            <a:extLst>
              <a:ext uri="{FF2B5EF4-FFF2-40B4-BE49-F238E27FC236}">
                <a16:creationId xmlns:a16="http://schemas.microsoft.com/office/drawing/2014/main" id="{6C16F6A9-A2B8-1EBC-F06D-FDC39B2BFFE6}"/>
              </a:ext>
            </a:extLst>
          </p:cNvPr>
          <p:cNvSpPr/>
          <p:nvPr/>
        </p:nvSpPr>
        <p:spPr>
          <a:xfrm rot="16200000">
            <a:off x="3867855" y="2442278"/>
            <a:ext cx="184606" cy="682374"/>
          </a:xfrm>
          <a:prstGeom prst="downArrow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Helvetica" pitchFamily="2" charset="0"/>
            </a:endParaRPr>
          </a:p>
        </p:txBody>
      </p:sp>
      <p:pic>
        <p:nvPicPr>
          <p:cNvPr id="46" name="Picture 2" descr="CFX96 Dx Real-Time PCR Detection Systems for In Vitro Diagnostics (IVD) |  Bio-Rad">
            <a:extLst>
              <a:ext uri="{FF2B5EF4-FFF2-40B4-BE49-F238E27FC236}">
                <a16:creationId xmlns:a16="http://schemas.microsoft.com/office/drawing/2014/main" id="{070F7E4F-604B-E5D2-4BC6-BBDACBED858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26" r="22049"/>
          <a:stretch/>
        </p:blipFill>
        <p:spPr bwMode="auto">
          <a:xfrm>
            <a:off x="4420304" y="1670942"/>
            <a:ext cx="1203516" cy="13927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27B18333-813C-0130-959A-09E009CEABB7}"/>
              </a:ext>
            </a:extLst>
          </p:cNvPr>
          <p:cNvSpPr txBox="1"/>
          <p:nvPr/>
        </p:nvSpPr>
        <p:spPr>
          <a:xfrm>
            <a:off x="4458446" y="3045581"/>
            <a:ext cx="1127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Helvetica" pitchFamily="2" charset="0"/>
              </a:rPr>
              <a:t>Real-time PCR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D4ACAD2-83F7-6997-262B-9AB6D10C3E09}"/>
              </a:ext>
            </a:extLst>
          </p:cNvPr>
          <p:cNvSpPr txBox="1"/>
          <p:nvPr/>
        </p:nvSpPr>
        <p:spPr>
          <a:xfrm>
            <a:off x="5623820" y="2165769"/>
            <a:ext cx="657552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 err="1">
                <a:latin typeface="Helvetica" pitchFamily="2" charset="0"/>
              </a:rPr>
              <a:t>MxA</a:t>
            </a:r>
            <a:endParaRPr lang="en-US" sz="1100" i="1" dirty="0">
              <a:latin typeface="Helvetica" pitchFamily="2" charset="0"/>
            </a:endParaRPr>
          </a:p>
          <a:p>
            <a:r>
              <a:rPr lang="en-US" sz="1100" i="1" dirty="0">
                <a:latin typeface="Helvetica" pitchFamily="2" charset="0"/>
              </a:rPr>
              <a:t>ADAR1</a:t>
            </a:r>
          </a:p>
          <a:p>
            <a:r>
              <a:rPr lang="en-US" sz="1100" i="1" dirty="0">
                <a:latin typeface="Helvetica" pitchFamily="2" charset="0"/>
              </a:rPr>
              <a:t>ISG56</a:t>
            </a:r>
          </a:p>
        </p:txBody>
      </p:sp>
      <p:grpSp>
        <p:nvGrpSpPr>
          <p:cNvPr id="49" name="Group 48">
            <a:extLst>
              <a:ext uri="{FF2B5EF4-FFF2-40B4-BE49-F238E27FC236}">
                <a16:creationId xmlns:a16="http://schemas.microsoft.com/office/drawing/2014/main" id="{8B61300B-AFDE-3FF4-FC59-A97DF44BC48E}"/>
              </a:ext>
            </a:extLst>
          </p:cNvPr>
          <p:cNvGrpSpPr/>
          <p:nvPr/>
        </p:nvGrpSpPr>
        <p:grpSpPr>
          <a:xfrm>
            <a:off x="1683984" y="3685113"/>
            <a:ext cx="7124700" cy="2629580"/>
            <a:chOff x="457159" y="3813386"/>
            <a:chExt cx="7124700" cy="2629580"/>
          </a:xfrm>
        </p:grpSpPr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F03B917B-D94C-3556-D67E-5A63B2F8659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57159" y="3813386"/>
              <a:ext cx="7124700" cy="2590800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5C9984E7-C61E-38C3-7DE4-DB425F89ECA8}"/>
                </a:ext>
              </a:extLst>
            </p:cNvPr>
            <p:cNvSpPr txBox="1"/>
            <p:nvPr/>
          </p:nvSpPr>
          <p:spPr>
            <a:xfrm>
              <a:off x="4568517" y="6193816"/>
              <a:ext cx="151529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pitchFamily="2" charset="0"/>
                </a:rPr>
                <a:t>Samples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EDA98114-5175-6E84-ACA0-DC1B1D4E2D8F}"/>
                </a:ext>
              </a:extLst>
            </p:cNvPr>
            <p:cNvSpPr txBox="1"/>
            <p:nvPr/>
          </p:nvSpPr>
          <p:spPr>
            <a:xfrm>
              <a:off x="1722889" y="6196745"/>
              <a:ext cx="151529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Helvetica" pitchFamily="2" charset="0"/>
                </a:rPr>
                <a:t>Controls</a:t>
              </a:r>
            </a:p>
          </p:txBody>
        </p: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13548DDD-CCCC-16CF-04A0-6A157464A6FB}"/>
              </a:ext>
            </a:extLst>
          </p:cNvPr>
          <p:cNvSpPr txBox="1"/>
          <p:nvPr/>
        </p:nvSpPr>
        <p:spPr>
          <a:xfrm>
            <a:off x="1250412" y="376566"/>
            <a:ext cx="3836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Helvetica" pitchFamily="2" charset="0"/>
              </a:rPr>
              <a:t>A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7F9C369-57E5-26A6-C04A-25D2B6EACAA3}"/>
              </a:ext>
            </a:extLst>
          </p:cNvPr>
          <p:cNvSpPr txBox="1"/>
          <p:nvPr/>
        </p:nvSpPr>
        <p:spPr>
          <a:xfrm>
            <a:off x="1250412" y="3688980"/>
            <a:ext cx="3836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Helvetica" pitchFamily="2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2117761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Macintosh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o Jun Yung</dc:creator>
  <cp:lastModifiedBy>Woo Jun Yung</cp:lastModifiedBy>
  <cp:revision>1</cp:revision>
  <dcterms:created xsi:type="dcterms:W3CDTF">2023-11-08T05:39:02Z</dcterms:created>
  <dcterms:modified xsi:type="dcterms:W3CDTF">2023-11-08T05:39:43Z</dcterms:modified>
</cp:coreProperties>
</file>